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59" r:id="rId3"/>
    <p:sldId id="262" r:id="rId4"/>
    <p:sldId id="261" r:id="rId5"/>
    <p:sldId id="263" r:id="rId6"/>
    <p:sldId id="257" r:id="rId7"/>
    <p:sldId id="260" r:id="rId8"/>
    <p:sldId id="258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8E4AC9F-6E8E-4536-83E4-DA2D7FC1ED61}" v="11" dt="2023-04-28T14:18:03.80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443" autoAdjust="0"/>
  </p:normalViewPr>
  <p:slideViewPr>
    <p:cSldViewPr snapToGrid="0">
      <p:cViewPr varScale="1">
        <p:scale>
          <a:sx n="62" d="100"/>
          <a:sy n="62" d="100"/>
        </p:scale>
        <p:origin x="140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ng, Ziliang" userId="81d16429-0f9a-4185-9336-86602ad2fda1" providerId="ADAL" clId="{C8E4AC9F-6E8E-4536-83E4-DA2D7FC1ED61}"/>
    <pc:docChg chg="undo custSel modSld">
      <pc:chgData name="Song, Ziliang" userId="81d16429-0f9a-4185-9336-86602ad2fda1" providerId="ADAL" clId="{C8E4AC9F-6E8E-4536-83E4-DA2D7FC1ED61}" dt="2023-04-28T14:18:18.236" v="170" actId="1076"/>
      <pc:docMkLst>
        <pc:docMk/>
      </pc:docMkLst>
      <pc:sldChg chg="modSp mod">
        <pc:chgData name="Song, Ziliang" userId="81d16429-0f9a-4185-9336-86602ad2fda1" providerId="ADAL" clId="{C8E4AC9F-6E8E-4536-83E4-DA2D7FC1ED61}" dt="2023-04-28T14:10:07.486" v="62" actId="1076"/>
        <pc:sldMkLst>
          <pc:docMk/>
          <pc:sldMk cId="2340565218" sldId="256"/>
        </pc:sldMkLst>
        <pc:spChg chg="mod ord">
          <ac:chgData name="Song, Ziliang" userId="81d16429-0f9a-4185-9336-86602ad2fda1" providerId="ADAL" clId="{C8E4AC9F-6E8E-4536-83E4-DA2D7FC1ED61}" dt="2023-04-28T14:10:07.486" v="62" actId="1076"/>
          <ac:spMkLst>
            <pc:docMk/>
            <pc:sldMk cId="2340565218" sldId="256"/>
            <ac:spMk id="2" creationId="{4212C1FF-725C-7428-D455-1C097F03105A}"/>
          </ac:spMkLst>
        </pc:spChg>
      </pc:sldChg>
      <pc:sldChg chg="modSp mod modNotesTx">
        <pc:chgData name="Song, Ziliang" userId="81d16429-0f9a-4185-9336-86602ad2fda1" providerId="ADAL" clId="{C8E4AC9F-6E8E-4536-83E4-DA2D7FC1ED61}" dt="2023-04-28T14:16:33.545" v="136" actId="1076"/>
        <pc:sldMkLst>
          <pc:docMk/>
          <pc:sldMk cId="113164147" sldId="257"/>
        </pc:sldMkLst>
        <pc:spChg chg="mod ord">
          <ac:chgData name="Song, Ziliang" userId="81d16429-0f9a-4185-9336-86602ad2fda1" providerId="ADAL" clId="{C8E4AC9F-6E8E-4536-83E4-DA2D7FC1ED61}" dt="2023-04-28T14:16:33.545" v="136" actId="1076"/>
          <ac:spMkLst>
            <pc:docMk/>
            <pc:sldMk cId="113164147" sldId="257"/>
            <ac:spMk id="2" creationId="{ED0F2212-3CF0-00F3-3830-FD677E944BBF}"/>
          </ac:spMkLst>
        </pc:spChg>
      </pc:sldChg>
      <pc:sldChg chg="modSp mod modNotesTx">
        <pc:chgData name="Song, Ziliang" userId="81d16429-0f9a-4185-9336-86602ad2fda1" providerId="ADAL" clId="{C8E4AC9F-6E8E-4536-83E4-DA2D7FC1ED61}" dt="2023-04-28T14:18:18.236" v="170" actId="1076"/>
        <pc:sldMkLst>
          <pc:docMk/>
          <pc:sldMk cId="1498467712" sldId="258"/>
        </pc:sldMkLst>
        <pc:spChg chg="mod ord">
          <ac:chgData name="Song, Ziliang" userId="81d16429-0f9a-4185-9336-86602ad2fda1" providerId="ADAL" clId="{C8E4AC9F-6E8E-4536-83E4-DA2D7FC1ED61}" dt="2023-04-28T14:18:18.236" v="170" actId="1076"/>
          <ac:spMkLst>
            <pc:docMk/>
            <pc:sldMk cId="1498467712" sldId="258"/>
            <ac:spMk id="2" creationId="{693B6982-3461-7AEB-A530-9272B9C3E940}"/>
          </ac:spMkLst>
        </pc:spChg>
      </pc:sldChg>
      <pc:sldChg chg="addSp delSp modSp mod modNotesTx">
        <pc:chgData name="Song, Ziliang" userId="81d16429-0f9a-4185-9336-86602ad2fda1" providerId="ADAL" clId="{C8E4AC9F-6E8E-4536-83E4-DA2D7FC1ED61}" dt="2023-04-28T14:10:00.823" v="61" actId="1076"/>
        <pc:sldMkLst>
          <pc:docMk/>
          <pc:sldMk cId="2753348551" sldId="259"/>
        </pc:sldMkLst>
        <pc:spChg chg="mod ord">
          <ac:chgData name="Song, Ziliang" userId="81d16429-0f9a-4185-9336-86602ad2fda1" providerId="ADAL" clId="{C8E4AC9F-6E8E-4536-83E4-DA2D7FC1ED61}" dt="2023-04-28T14:10:00.823" v="61" actId="1076"/>
          <ac:spMkLst>
            <pc:docMk/>
            <pc:sldMk cId="2753348551" sldId="259"/>
            <ac:spMk id="2" creationId="{70BA15E2-FC30-3853-AB08-834E07CD1318}"/>
          </ac:spMkLst>
        </pc:spChg>
        <pc:graphicFrameChg chg="add del mod">
          <ac:chgData name="Song, Ziliang" userId="81d16429-0f9a-4185-9336-86602ad2fda1" providerId="ADAL" clId="{C8E4AC9F-6E8E-4536-83E4-DA2D7FC1ED61}" dt="2023-04-28T14:09:07.383" v="43"/>
          <ac:graphicFrameMkLst>
            <pc:docMk/>
            <pc:sldMk cId="2753348551" sldId="259"/>
            <ac:graphicFrameMk id="4" creationId="{280B623A-FF79-FD5B-8FC5-E5918BE288B0}"/>
          </ac:graphicFrameMkLst>
        </pc:graphicFrameChg>
        <pc:graphicFrameChg chg="add del mod">
          <ac:chgData name="Song, Ziliang" userId="81d16429-0f9a-4185-9336-86602ad2fda1" providerId="ADAL" clId="{C8E4AC9F-6E8E-4536-83E4-DA2D7FC1ED61}" dt="2023-04-28T14:09:15.200" v="45"/>
          <ac:graphicFrameMkLst>
            <pc:docMk/>
            <pc:sldMk cId="2753348551" sldId="259"/>
            <ac:graphicFrameMk id="5" creationId="{B180F497-7A07-DADE-172E-AC5924445848}"/>
          </ac:graphicFrameMkLst>
        </pc:graphicFrameChg>
      </pc:sldChg>
      <pc:sldChg chg="modSp mod modNotesTx">
        <pc:chgData name="Song, Ziliang" userId="81d16429-0f9a-4185-9336-86602ad2fda1" providerId="ADAL" clId="{C8E4AC9F-6E8E-4536-83E4-DA2D7FC1ED61}" dt="2023-04-28T14:17:29.134" v="154" actId="1076"/>
        <pc:sldMkLst>
          <pc:docMk/>
          <pc:sldMk cId="2675529939" sldId="260"/>
        </pc:sldMkLst>
        <pc:spChg chg="mod ord">
          <ac:chgData name="Song, Ziliang" userId="81d16429-0f9a-4185-9336-86602ad2fda1" providerId="ADAL" clId="{C8E4AC9F-6E8E-4536-83E4-DA2D7FC1ED61}" dt="2023-04-28T14:17:29.134" v="154" actId="1076"/>
          <ac:spMkLst>
            <pc:docMk/>
            <pc:sldMk cId="2675529939" sldId="260"/>
            <ac:spMk id="2" creationId="{855795BF-F9CC-3E8B-2654-7B45AF43CDFF}"/>
          </ac:spMkLst>
        </pc:spChg>
      </pc:sldChg>
      <pc:sldChg chg="modSp mod modNotesTx">
        <pc:chgData name="Song, Ziliang" userId="81d16429-0f9a-4185-9336-86602ad2fda1" providerId="ADAL" clId="{C8E4AC9F-6E8E-4536-83E4-DA2D7FC1ED61}" dt="2023-04-28T14:12:13.168" v="95" actId="1076"/>
        <pc:sldMkLst>
          <pc:docMk/>
          <pc:sldMk cId="357226950" sldId="261"/>
        </pc:sldMkLst>
        <pc:spChg chg="mod ord">
          <ac:chgData name="Song, Ziliang" userId="81d16429-0f9a-4185-9336-86602ad2fda1" providerId="ADAL" clId="{C8E4AC9F-6E8E-4536-83E4-DA2D7FC1ED61}" dt="2023-04-28T14:12:13.168" v="95" actId="1076"/>
          <ac:spMkLst>
            <pc:docMk/>
            <pc:sldMk cId="357226950" sldId="261"/>
            <ac:spMk id="2" creationId="{2B800F5D-163B-A95B-CF4C-920FA861BD94}"/>
          </ac:spMkLst>
        </pc:spChg>
      </pc:sldChg>
      <pc:sldChg chg="modSp mod modNotesTx">
        <pc:chgData name="Song, Ziliang" userId="81d16429-0f9a-4185-9336-86602ad2fda1" providerId="ADAL" clId="{C8E4AC9F-6E8E-4536-83E4-DA2D7FC1ED61}" dt="2023-04-28T14:11:21.150" v="81" actId="1076"/>
        <pc:sldMkLst>
          <pc:docMk/>
          <pc:sldMk cId="1229599793" sldId="262"/>
        </pc:sldMkLst>
        <pc:spChg chg="mod ord">
          <ac:chgData name="Song, Ziliang" userId="81d16429-0f9a-4185-9336-86602ad2fda1" providerId="ADAL" clId="{C8E4AC9F-6E8E-4536-83E4-DA2D7FC1ED61}" dt="2023-04-28T14:11:21.150" v="81" actId="1076"/>
          <ac:spMkLst>
            <pc:docMk/>
            <pc:sldMk cId="1229599793" sldId="262"/>
            <ac:spMk id="3" creationId="{41C9D60A-D47C-72BE-C365-CB44E6AA8D52}"/>
          </ac:spMkLst>
        </pc:spChg>
      </pc:sldChg>
      <pc:sldChg chg="modSp mod modNotesTx">
        <pc:chgData name="Song, Ziliang" userId="81d16429-0f9a-4185-9336-86602ad2fda1" providerId="ADAL" clId="{C8E4AC9F-6E8E-4536-83E4-DA2D7FC1ED61}" dt="2023-04-28T14:15:31.275" v="114" actId="1076"/>
        <pc:sldMkLst>
          <pc:docMk/>
          <pc:sldMk cId="3077770011" sldId="263"/>
        </pc:sldMkLst>
        <pc:spChg chg="mod ord">
          <ac:chgData name="Song, Ziliang" userId="81d16429-0f9a-4185-9336-86602ad2fda1" providerId="ADAL" clId="{C8E4AC9F-6E8E-4536-83E4-DA2D7FC1ED61}" dt="2023-04-28T14:15:31.275" v="114" actId="1076"/>
          <ac:spMkLst>
            <pc:docMk/>
            <pc:sldMk cId="3077770011" sldId="263"/>
            <ac:spMk id="2" creationId="{234B0F0F-7F68-4D1D-5211-AFC62B85FDB0}"/>
          </ac:spMkLst>
        </pc:spChg>
      </pc:sldChg>
    </pc:docChg>
  </pc:docChgLst>
  <pc:docChgLst>
    <pc:chgData name="Song, Ziliang" userId="81d16429-0f9a-4185-9336-86602ad2fda1" providerId="ADAL" clId="{CA9780B2-6B23-4157-AEEC-5014C6A61992}"/>
    <pc:docChg chg="custSel modSld">
      <pc:chgData name="Song, Ziliang" userId="81d16429-0f9a-4185-9336-86602ad2fda1" providerId="ADAL" clId="{CA9780B2-6B23-4157-AEEC-5014C6A61992}" dt="2023-01-20T05:21:08.311" v="389" actId="167"/>
      <pc:docMkLst>
        <pc:docMk/>
      </pc:docMkLst>
      <pc:sldChg chg="addSp delSp modSp mod">
        <pc:chgData name="Song, Ziliang" userId="81d16429-0f9a-4185-9336-86602ad2fda1" providerId="ADAL" clId="{CA9780B2-6B23-4157-AEEC-5014C6A61992}" dt="2023-01-20T04:19:36.324" v="165" actId="1076"/>
        <pc:sldMkLst>
          <pc:docMk/>
          <pc:sldMk cId="2340565218" sldId="256"/>
        </pc:sldMkLst>
        <pc:picChg chg="add mod modCrop">
          <ac:chgData name="Song, Ziliang" userId="81d16429-0f9a-4185-9336-86602ad2fda1" providerId="ADAL" clId="{CA9780B2-6B23-4157-AEEC-5014C6A61992}" dt="2023-01-20T04:19:36.324" v="165" actId="1076"/>
          <ac:picMkLst>
            <pc:docMk/>
            <pc:sldMk cId="2340565218" sldId="256"/>
            <ac:picMk id="3" creationId="{81A68ACD-3A1C-A69F-2D6E-ECA9A52409E2}"/>
          </ac:picMkLst>
        </pc:picChg>
        <pc:picChg chg="del">
          <ac:chgData name="Song, Ziliang" userId="81d16429-0f9a-4185-9336-86602ad2fda1" providerId="ADAL" clId="{CA9780B2-6B23-4157-AEEC-5014C6A61992}" dt="2023-01-20T04:19:00.913" v="157" actId="478"/>
          <ac:picMkLst>
            <pc:docMk/>
            <pc:sldMk cId="2340565218" sldId="256"/>
            <ac:picMk id="8" creationId="{290F0489-715A-7891-6151-1381A048720E}"/>
          </ac:picMkLst>
        </pc:picChg>
      </pc:sldChg>
      <pc:sldChg chg="addSp delSp modSp mod">
        <pc:chgData name="Song, Ziliang" userId="81d16429-0f9a-4185-9336-86602ad2fda1" providerId="ADAL" clId="{CA9780B2-6B23-4157-AEEC-5014C6A61992}" dt="2023-01-20T04:17:05.433" v="156" actId="1076"/>
        <pc:sldMkLst>
          <pc:docMk/>
          <pc:sldMk cId="113164147" sldId="257"/>
        </pc:sldMkLst>
        <pc:spChg chg="add del">
          <ac:chgData name="Song, Ziliang" userId="81d16429-0f9a-4185-9336-86602ad2fda1" providerId="ADAL" clId="{CA9780B2-6B23-4157-AEEC-5014C6A61992}" dt="2023-01-20T04:10:34.132" v="6"/>
          <ac:spMkLst>
            <pc:docMk/>
            <pc:sldMk cId="113164147" sldId="257"/>
            <ac:spMk id="3" creationId="{DA0262E6-173F-9411-7661-45F0B9005072}"/>
          </ac:spMkLst>
        </pc:spChg>
        <pc:spChg chg="mod">
          <ac:chgData name="Song, Ziliang" userId="81d16429-0f9a-4185-9336-86602ad2fda1" providerId="ADAL" clId="{CA9780B2-6B23-4157-AEEC-5014C6A61992}" dt="2023-01-20T04:14:29.828" v="121" actId="1036"/>
          <ac:spMkLst>
            <pc:docMk/>
            <pc:sldMk cId="113164147" sldId="257"/>
            <ac:spMk id="15" creationId="{036F0DAA-EA07-578B-65C4-9B3328888164}"/>
          </ac:spMkLst>
        </pc:spChg>
        <pc:spChg chg="mod">
          <ac:chgData name="Song, Ziliang" userId="81d16429-0f9a-4185-9336-86602ad2fda1" providerId="ADAL" clId="{CA9780B2-6B23-4157-AEEC-5014C6A61992}" dt="2023-01-20T04:15:42.348" v="140" actId="14100"/>
          <ac:spMkLst>
            <pc:docMk/>
            <pc:sldMk cId="113164147" sldId="257"/>
            <ac:spMk id="18" creationId="{3DF47C10-A10B-8FF2-E952-C64A912CB3A2}"/>
          </ac:spMkLst>
        </pc:spChg>
        <pc:spChg chg="mod">
          <ac:chgData name="Song, Ziliang" userId="81d16429-0f9a-4185-9336-86602ad2fda1" providerId="ADAL" clId="{CA9780B2-6B23-4157-AEEC-5014C6A61992}" dt="2023-01-20T04:17:05.433" v="156" actId="1076"/>
          <ac:spMkLst>
            <pc:docMk/>
            <pc:sldMk cId="113164147" sldId="257"/>
            <ac:spMk id="19" creationId="{CD9E9B2B-1705-7531-940B-B6A5332BA1D8}"/>
          </ac:spMkLst>
        </pc:spChg>
        <pc:spChg chg="mod">
          <ac:chgData name="Song, Ziliang" userId="81d16429-0f9a-4185-9336-86602ad2fda1" providerId="ADAL" clId="{CA9780B2-6B23-4157-AEEC-5014C6A61992}" dt="2023-01-20T04:16:19.202" v="149" actId="14100"/>
          <ac:spMkLst>
            <pc:docMk/>
            <pc:sldMk cId="113164147" sldId="257"/>
            <ac:spMk id="20" creationId="{0A802746-33E3-C915-398C-C35D497F00F2}"/>
          </ac:spMkLst>
        </pc:spChg>
        <pc:spChg chg="mod">
          <ac:chgData name="Song, Ziliang" userId="81d16429-0f9a-4185-9336-86602ad2fda1" providerId="ADAL" clId="{CA9780B2-6B23-4157-AEEC-5014C6A61992}" dt="2023-01-20T04:16:32.808" v="151" actId="1076"/>
          <ac:spMkLst>
            <pc:docMk/>
            <pc:sldMk cId="113164147" sldId="257"/>
            <ac:spMk id="21" creationId="{08735AFA-D780-2363-12C7-62272B9F806F}"/>
          </ac:spMkLst>
        </pc:spChg>
        <pc:spChg chg="mod">
          <ac:chgData name="Song, Ziliang" userId="81d16429-0f9a-4185-9336-86602ad2fda1" providerId="ADAL" clId="{CA9780B2-6B23-4157-AEEC-5014C6A61992}" dt="2023-01-20T04:16:46.282" v="154" actId="14100"/>
          <ac:spMkLst>
            <pc:docMk/>
            <pc:sldMk cId="113164147" sldId="257"/>
            <ac:spMk id="22" creationId="{5D0B1245-0232-5057-270B-829F3895312F}"/>
          </ac:spMkLst>
        </pc:spChg>
        <pc:spChg chg="mod">
          <ac:chgData name="Song, Ziliang" userId="81d16429-0f9a-4185-9336-86602ad2fda1" providerId="ADAL" clId="{CA9780B2-6B23-4157-AEEC-5014C6A61992}" dt="2023-01-20T04:16:52.058" v="155" actId="1076"/>
          <ac:spMkLst>
            <pc:docMk/>
            <pc:sldMk cId="113164147" sldId="257"/>
            <ac:spMk id="23" creationId="{5234ACA6-66CA-7574-7503-7D293F92179C}"/>
          </ac:spMkLst>
        </pc:spChg>
        <pc:picChg chg="add mod ord modCrop">
          <ac:chgData name="Song, Ziliang" userId="81d16429-0f9a-4185-9336-86602ad2fda1" providerId="ADAL" clId="{CA9780B2-6B23-4157-AEEC-5014C6A61992}" dt="2023-01-20T04:11:09.408" v="14" actId="167"/>
          <ac:picMkLst>
            <pc:docMk/>
            <pc:sldMk cId="113164147" sldId="257"/>
            <ac:picMk id="4" creationId="{F4FDE20C-9617-1589-218B-117147826FFD}"/>
          </ac:picMkLst>
        </pc:picChg>
        <pc:picChg chg="del">
          <ac:chgData name="Song, Ziliang" userId="81d16429-0f9a-4185-9336-86602ad2fda1" providerId="ADAL" clId="{CA9780B2-6B23-4157-AEEC-5014C6A61992}" dt="2023-01-20T04:10:28.747" v="0" actId="478"/>
          <ac:picMkLst>
            <pc:docMk/>
            <pc:sldMk cId="113164147" sldId="257"/>
            <ac:picMk id="26" creationId="{878FF062-2976-46B2-BC25-8A959565BDBC}"/>
          </ac:picMkLst>
        </pc:picChg>
        <pc:cxnChg chg="mod">
          <ac:chgData name="Song, Ziliang" userId="81d16429-0f9a-4185-9336-86602ad2fda1" providerId="ADAL" clId="{CA9780B2-6B23-4157-AEEC-5014C6A61992}" dt="2023-01-20T04:14:43.906" v="127" actId="1035"/>
          <ac:cxnSpMkLst>
            <pc:docMk/>
            <pc:sldMk cId="113164147" sldId="257"/>
            <ac:cxnSpMk id="6" creationId="{935832D7-7E81-CCCB-ED47-A5A3B1CDFCA8}"/>
          </ac:cxnSpMkLst>
        </pc:cxnChg>
        <pc:cxnChg chg="mod">
          <ac:chgData name="Song, Ziliang" userId="81d16429-0f9a-4185-9336-86602ad2fda1" providerId="ADAL" clId="{CA9780B2-6B23-4157-AEEC-5014C6A61992}" dt="2023-01-20T04:16:00.417" v="145" actId="1035"/>
          <ac:cxnSpMkLst>
            <pc:docMk/>
            <pc:sldMk cId="113164147" sldId="257"/>
            <ac:cxnSpMk id="9" creationId="{BC8F7CE8-70A2-7997-FECC-D30686168609}"/>
          </ac:cxnSpMkLst>
        </pc:cxnChg>
        <pc:cxnChg chg="mod">
          <ac:chgData name="Song, Ziliang" userId="81d16429-0f9a-4185-9336-86602ad2fda1" providerId="ADAL" clId="{CA9780B2-6B23-4157-AEEC-5014C6A61992}" dt="2023-01-20T04:12:15.208" v="64" actId="14100"/>
          <ac:cxnSpMkLst>
            <pc:docMk/>
            <pc:sldMk cId="113164147" sldId="257"/>
            <ac:cxnSpMk id="10" creationId="{C151086A-0DE5-46DE-4E12-39CC42298B81}"/>
          </ac:cxnSpMkLst>
        </pc:cxnChg>
        <pc:cxnChg chg="mod">
          <ac:chgData name="Song, Ziliang" userId="81d16429-0f9a-4185-9336-86602ad2fda1" providerId="ADAL" clId="{CA9780B2-6B23-4157-AEEC-5014C6A61992}" dt="2023-01-20T04:13:36.940" v="111" actId="1036"/>
          <ac:cxnSpMkLst>
            <pc:docMk/>
            <pc:sldMk cId="113164147" sldId="257"/>
            <ac:cxnSpMk id="11" creationId="{048DA648-8E4C-D82B-493C-9938E81215E8}"/>
          </ac:cxnSpMkLst>
        </pc:cxnChg>
        <pc:cxnChg chg="mod">
          <ac:chgData name="Song, Ziliang" userId="81d16429-0f9a-4185-9336-86602ad2fda1" providerId="ADAL" clId="{CA9780B2-6B23-4157-AEEC-5014C6A61992}" dt="2023-01-20T04:13:34.116" v="110" actId="1036"/>
          <ac:cxnSpMkLst>
            <pc:docMk/>
            <pc:sldMk cId="113164147" sldId="257"/>
            <ac:cxnSpMk id="13" creationId="{B6B288FA-9EF3-5B87-70BC-7CD1D486FD07}"/>
          </ac:cxnSpMkLst>
        </pc:cxnChg>
        <pc:cxnChg chg="mod">
          <ac:chgData name="Song, Ziliang" userId="81d16429-0f9a-4185-9336-86602ad2fda1" providerId="ADAL" clId="{CA9780B2-6B23-4157-AEEC-5014C6A61992}" dt="2023-01-20T04:13:29.987" v="109" actId="1036"/>
          <ac:cxnSpMkLst>
            <pc:docMk/>
            <pc:sldMk cId="113164147" sldId="257"/>
            <ac:cxnSpMk id="14" creationId="{F9967E0F-E489-B79F-E3D3-DB8E2039C30A}"/>
          </ac:cxnSpMkLst>
        </pc:cxnChg>
      </pc:sldChg>
      <pc:sldChg chg="addSp delSp modSp mod">
        <pc:chgData name="Song, Ziliang" userId="81d16429-0f9a-4185-9336-86602ad2fda1" providerId="ADAL" clId="{CA9780B2-6B23-4157-AEEC-5014C6A61992}" dt="2023-01-20T05:21:08.311" v="389" actId="167"/>
        <pc:sldMkLst>
          <pc:docMk/>
          <pc:sldMk cId="1498467712" sldId="258"/>
        </pc:sldMkLst>
        <pc:picChg chg="add mod ord modCrop">
          <ac:chgData name="Song, Ziliang" userId="81d16429-0f9a-4185-9336-86602ad2fda1" providerId="ADAL" clId="{CA9780B2-6B23-4157-AEEC-5014C6A61992}" dt="2023-01-20T05:21:08.311" v="389" actId="167"/>
          <ac:picMkLst>
            <pc:docMk/>
            <pc:sldMk cId="1498467712" sldId="258"/>
            <ac:picMk id="3" creationId="{854D5C9F-632F-DAC0-5A80-3549DCD3C8CD}"/>
          </ac:picMkLst>
        </pc:picChg>
        <pc:picChg chg="del">
          <ac:chgData name="Song, Ziliang" userId="81d16429-0f9a-4185-9336-86602ad2fda1" providerId="ADAL" clId="{CA9780B2-6B23-4157-AEEC-5014C6A61992}" dt="2023-01-20T05:20:36.794" v="380" actId="478"/>
          <ac:picMkLst>
            <pc:docMk/>
            <pc:sldMk cId="1498467712" sldId="258"/>
            <ac:picMk id="5" creationId="{53DA2083-2018-E7A0-9DB9-296E1F71B143}"/>
          </ac:picMkLst>
        </pc:picChg>
      </pc:sldChg>
      <pc:sldChg chg="addSp delSp modSp mod">
        <pc:chgData name="Song, Ziliang" userId="81d16429-0f9a-4185-9336-86602ad2fda1" providerId="ADAL" clId="{CA9780B2-6B23-4157-AEEC-5014C6A61992}" dt="2023-01-20T04:22:03.478" v="174" actId="1076"/>
        <pc:sldMkLst>
          <pc:docMk/>
          <pc:sldMk cId="2753348551" sldId="259"/>
        </pc:sldMkLst>
        <pc:picChg chg="add mod modCrop">
          <ac:chgData name="Song, Ziliang" userId="81d16429-0f9a-4185-9336-86602ad2fda1" providerId="ADAL" clId="{CA9780B2-6B23-4157-AEEC-5014C6A61992}" dt="2023-01-20T04:22:03.478" v="174" actId="1076"/>
          <ac:picMkLst>
            <pc:docMk/>
            <pc:sldMk cId="2753348551" sldId="259"/>
            <ac:picMk id="3" creationId="{5A9B9862-1888-9569-9A30-935EEB1DBA57}"/>
          </ac:picMkLst>
        </pc:picChg>
        <pc:picChg chg="del">
          <ac:chgData name="Song, Ziliang" userId="81d16429-0f9a-4185-9336-86602ad2fda1" providerId="ADAL" clId="{CA9780B2-6B23-4157-AEEC-5014C6A61992}" dt="2023-01-20T04:21:28.973" v="166" actId="478"/>
          <ac:picMkLst>
            <pc:docMk/>
            <pc:sldMk cId="2753348551" sldId="259"/>
            <ac:picMk id="9" creationId="{2220F4B5-82EF-9314-B56C-84B699F09A28}"/>
          </ac:picMkLst>
        </pc:picChg>
      </pc:sldChg>
      <pc:sldChg chg="addSp delSp modSp mod">
        <pc:chgData name="Song, Ziliang" userId="81d16429-0f9a-4185-9336-86602ad2fda1" providerId="ADAL" clId="{CA9780B2-6B23-4157-AEEC-5014C6A61992}" dt="2023-01-20T05:18:12.075" v="379" actId="14100"/>
        <pc:sldMkLst>
          <pc:docMk/>
          <pc:sldMk cId="2675529939" sldId="260"/>
        </pc:sldMkLst>
        <pc:spChg chg="mod">
          <ac:chgData name="Song, Ziliang" userId="81d16429-0f9a-4185-9336-86602ad2fda1" providerId="ADAL" clId="{CA9780B2-6B23-4157-AEEC-5014C6A61992}" dt="2023-01-20T05:17:13.374" v="361" actId="14100"/>
          <ac:spMkLst>
            <pc:docMk/>
            <pc:sldMk cId="2675529939" sldId="260"/>
            <ac:spMk id="10" creationId="{C45BF706-2430-0C06-CE73-5EEDBC81E11F}"/>
          </ac:spMkLst>
        </pc:spChg>
        <pc:spChg chg="mod">
          <ac:chgData name="Song, Ziliang" userId="81d16429-0f9a-4185-9336-86602ad2fda1" providerId="ADAL" clId="{CA9780B2-6B23-4157-AEEC-5014C6A61992}" dt="2023-01-20T05:17:28.895" v="364" actId="14100"/>
          <ac:spMkLst>
            <pc:docMk/>
            <pc:sldMk cId="2675529939" sldId="260"/>
            <ac:spMk id="12" creationId="{2A560857-23AD-DCAC-BEA8-B061CDD2DD96}"/>
          </ac:spMkLst>
        </pc:spChg>
        <pc:spChg chg="mod">
          <ac:chgData name="Song, Ziliang" userId="81d16429-0f9a-4185-9336-86602ad2fda1" providerId="ADAL" clId="{CA9780B2-6B23-4157-AEEC-5014C6A61992}" dt="2023-01-20T05:18:12.075" v="379" actId="14100"/>
          <ac:spMkLst>
            <pc:docMk/>
            <pc:sldMk cId="2675529939" sldId="260"/>
            <ac:spMk id="14" creationId="{5CD02E59-C032-4EE4-34F1-9434D84EFF56}"/>
          </ac:spMkLst>
        </pc:spChg>
        <pc:picChg chg="del">
          <ac:chgData name="Song, Ziliang" userId="81d16429-0f9a-4185-9336-86602ad2fda1" providerId="ADAL" clId="{CA9780B2-6B23-4157-AEEC-5014C6A61992}" dt="2023-01-20T05:14:13.850" v="201" actId="478"/>
          <ac:picMkLst>
            <pc:docMk/>
            <pc:sldMk cId="2675529939" sldId="260"/>
            <ac:picMk id="3" creationId="{52B978B2-01B6-F079-0F40-6A44CCF937AA}"/>
          </ac:picMkLst>
        </pc:picChg>
        <pc:picChg chg="add mod ord modCrop">
          <ac:chgData name="Song, Ziliang" userId="81d16429-0f9a-4185-9336-86602ad2fda1" providerId="ADAL" clId="{CA9780B2-6B23-4157-AEEC-5014C6A61992}" dt="2023-01-20T05:15:06.105" v="209" actId="1076"/>
          <ac:picMkLst>
            <pc:docMk/>
            <pc:sldMk cId="2675529939" sldId="260"/>
            <ac:picMk id="6" creationId="{02E6150E-D7FD-8AE1-BB1C-9385AA541A8C}"/>
          </ac:picMkLst>
        </pc:picChg>
        <pc:cxnChg chg="mod">
          <ac:chgData name="Song, Ziliang" userId="81d16429-0f9a-4185-9336-86602ad2fda1" providerId="ADAL" clId="{CA9780B2-6B23-4157-AEEC-5014C6A61992}" dt="2023-01-20T05:16:12.184" v="294" actId="14100"/>
          <ac:cxnSpMkLst>
            <pc:docMk/>
            <pc:sldMk cId="2675529939" sldId="260"/>
            <ac:cxnSpMk id="4" creationId="{41BF29EE-1593-ED35-8FF9-15CBDE29EBF3}"/>
          </ac:cxnSpMkLst>
        </pc:cxnChg>
        <pc:cxnChg chg="mod">
          <ac:chgData name="Song, Ziliang" userId="81d16429-0f9a-4185-9336-86602ad2fda1" providerId="ADAL" clId="{CA9780B2-6B23-4157-AEEC-5014C6A61992}" dt="2023-01-20T05:15:18.906" v="218" actId="1036"/>
          <ac:cxnSpMkLst>
            <pc:docMk/>
            <pc:sldMk cId="2675529939" sldId="260"/>
            <ac:cxnSpMk id="5" creationId="{41CB61F7-7956-36D2-B84A-0923A0EB4893}"/>
          </ac:cxnSpMkLst>
        </pc:cxnChg>
        <pc:cxnChg chg="del">
          <ac:chgData name="Song, Ziliang" userId="81d16429-0f9a-4185-9336-86602ad2fda1" providerId="ADAL" clId="{CA9780B2-6B23-4157-AEEC-5014C6A61992}" dt="2023-01-20T05:15:22.704" v="219" actId="478"/>
          <ac:cxnSpMkLst>
            <pc:docMk/>
            <pc:sldMk cId="2675529939" sldId="260"/>
            <ac:cxnSpMk id="7" creationId="{6152E609-41A0-22EC-3834-4725D68A1969}"/>
          </ac:cxnSpMkLst>
        </pc:cxnChg>
        <pc:cxnChg chg="del">
          <ac:chgData name="Song, Ziliang" userId="81d16429-0f9a-4185-9336-86602ad2fda1" providerId="ADAL" clId="{CA9780B2-6B23-4157-AEEC-5014C6A61992}" dt="2023-01-20T05:16:18.585" v="296" actId="478"/>
          <ac:cxnSpMkLst>
            <pc:docMk/>
            <pc:sldMk cId="2675529939" sldId="260"/>
            <ac:cxnSpMk id="9" creationId="{2FF37CB3-E905-ABA8-7AA4-5B2760098B7B}"/>
          </ac:cxnSpMkLst>
        </pc:cxnChg>
        <pc:cxnChg chg="add mod">
          <ac:chgData name="Song, Ziliang" userId="81d16429-0f9a-4185-9336-86602ad2fda1" providerId="ADAL" clId="{CA9780B2-6B23-4157-AEEC-5014C6A61992}" dt="2023-01-20T05:15:39.474" v="287" actId="1037"/>
          <ac:cxnSpMkLst>
            <pc:docMk/>
            <pc:sldMk cId="2675529939" sldId="260"/>
            <ac:cxnSpMk id="16" creationId="{897F6C2B-EACA-F062-57A7-07CBFBA549ED}"/>
          </ac:cxnSpMkLst>
        </pc:cxnChg>
        <pc:cxnChg chg="add mod">
          <ac:chgData name="Song, Ziliang" userId="81d16429-0f9a-4185-9336-86602ad2fda1" providerId="ADAL" clId="{CA9780B2-6B23-4157-AEEC-5014C6A61992}" dt="2023-01-20T05:16:29.456" v="351" actId="1038"/>
          <ac:cxnSpMkLst>
            <pc:docMk/>
            <pc:sldMk cId="2675529939" sldId="260"/>
            <ac:cxnSpMk id="20" creationId="{66EFE5A9-33D0-1973-DC70-9623CDC2FDCD}"/>
          </ac:cxnSpMkLst>
        </pc:cxnChg>
      </pc:sldChg>
      <pc:sldChg chg="addSp delSp modSp mod">
        <pc:chgData name="Song, Ziliang" userId="81d16429-0f9a-4185-9336-86602ad2fda1" providerId="ADAL" clId="{CA9780B2-6B23-4157-AEEC-5014C6A61992}" dt="2023-01-20T04:28:36.830" v="191" actId="167"/>
        <pc:sldMkLst>
          <pc:docMk/>
          <pc:sldMk cId="357226950" sldId="261"/>
        </pc:sldMkLst>
        <pc:picChg chg="del">
          <ac:chgData name="Song, Ziliang" userId="81d16429-0f9a-4185-9336-86602ad2fda1" providerId="ADAL" clId="{CA9780B2-6B23-4157-AEEC-5014C6A61992}" dt="2023-01-20T04:28:04.474" v="182" actId="478"/>
          <ac:picMkLst>
            <pc:docMk/>
            <pc:sldMk cId="357226950" sldId="261"/>
            <ac:picMk id="3" creationId="{8BCCD411-3808-115B-DD6D-26BF1C815784}"/>
          </ac:picMkLst>
        </pc:picChg>
        <pc:picChg chg="add mod ord modCrop">
          <ac:chgData name="Song, Ziliang" userId="81d16429-0f9a-4185-9336-86602ad2fda1" providerId="ADAL" clId="{CA9780B2-6B23-4157-AEEC-5014C6A61992}" dt="2023-01-20T04:28:36.830" v="191" actId="167"/>
          <ac:picMkLst>
            <pc:docMk/>
            <pc:sldMk cId="357226950" sldId="261"/>
            <ac:picMk id="4" creationId="{215BF896-3D68-14E0-E988-23412D369AA8}"/>
          </ac:picMkLst>
        </pc:picChg>
      </pc:sldChg>
      <pc:sldChg chg="addSp delSp modSp mod">
        <pc:chgData name="Song, Ziliang" userId="81d16429-0f9a-4185-9336-86602ad2fda1" providerId="ADAL" clId="{CA9780B2-6B23-4157-AEEC-5014C6A61992}" dt="2023-01-20T04:25:06.779" v="181" actId="1076"/>
        <pc:sldMkLst>
          <pc:docMk/>
          <pc:sldMk cId="1229599793" sldId="262"/>
        </pc:sldMkLst>
        <pc:picChg chg="del">
          <ac:chgData name="Song, Ziliang" userId="81d16429-0f9a-4185-9336-86602ad2fda1" providerId="ADAL" clId="{CA9780B2-6B23-4157-AEEC-5014C6A61992}" dt="2023-01-20T04:24:38.388" v="175" actId="478"/>
          <ac:picMkLst>
            <pc:docMk/>
            <pc:sldMk cId="1229599793" sldId="262"/>
            <ac:picMk id="2" creationId="{7EF491DE-5B50-CC9A-DA60-57028B7D5284}"/>
          </ac:picMkLst>
        </pc:picChg>
        <pc:picChg chg="add mod modCrop">
          <ac:chgData name="Song, Ziliang" userId="81d16429-0f9a-4185-9336-86602ad2fda1" providerId="ADAL" clId="{CA9780B2-6B23-4157-AEEC-5014C6A61992}" dt="2023-01-20T04:25:06.779" v="181" actId="1076"/>
          <ac:picMkLst>
            <pc:docMk/>
            <pc:sldMk cId="1229599793" sldId="262"/>
            <ac:picMk id="4" creationId="{AC3FB70D-971E-B71F-72A1-B3EB0033E4A4}"/>
          </ac:picMkLst>
        </pc:picChg>
      </pc:sldChg>
      <pc:sldChg chg="addSp delSp modSp mod">
        <pc:chgData name="Song, Ziliang" userId="81d16429-0f9a-4185-9336-86602ad2fda1" providerId="ADAL" clId="{CA9780B2-6B23-4157-AEEC-5014C6A61992}" dt="2023-01-20T04:31:43.557" v="200" actId="1076"/>
        <pc:sldMkLst>
          <pc:docMk/>
          <pc:sldMk cId="3077770011" sldId="263"/>
        </pc:sldMkLst>
        <pc:picChg chg="add mod modCrop">
          <ac:chgData name="Song, Ziliang" userId="81d16429-0f9a-4185-9336-86602ad2fda1" providerId="ADAL" clId="{CA9780B2-6B23-4157-AEEC-5014C6A61992}" dt="2023-01-20T04:31:43.557" v="200" actId="1076"/>
          <ac:picMkLst>
            <pc:docMk/>
            <pc:sldMk cId="3077770011" sldId="263"/>
            <ac:picMk id="3" creationId="{5A9C9AE0-A431-CBDA-7DE5-AA2044713AB4}"/>
          </ac:picMkLst>
        </pc:picChg>
        <pc:picChg chg="del">
          <ac:chgData name="Song, Ziliang" userId="81d16429-0f9a-4185-9336-86602ad2fda1" providerId="ADAL" clId="{CA9780B2-6B23-4157-AEEC-5014C6A61992}" dt="2023-01-20T04:31:07.938" v="192" actId="478"/>
          <ac:picMkLst>
            <pc:docMk/>
            <pc:sldMk cId="3077770011" sldId="263"/>
            <ac:picMk id="4" creationId="{90C3D864-66E5-235E-F60D-97812B682AD6}"/>
          </ac:picMkLst>
        </pc:picChg>
      </pc:sldChg>
    </pc:docChg>
  </pc:docChgLst>
  <pc:docChgLst>
    <pc:chgData name="Song, Ziliang" userId="81d16429-0f9a-4185-9336-86602ad2fda1" providerId="ADAL" clId="{01877568-1086-49AD-8E62-3486DBC9DE55}"/>
    <pc:docChg chg="undo redo custSel addSld delSld modSld sldOrd modMainMaster">
      <pc:chgData name="Song, Ziliang" userId="81d16429-0f9a-4185-9336-86602ad2fda1" providerId="ADAL" clId="{01877568-1086-49AD-8E62-3486DBC9DE55}" dt="2023-01-19T08:15:27.782" v="888" actId="20577"/>
      <pc:docMkLst>
        <pc:docMk/>
      </pc:docMkLst>
      <pc:sldChg chg="addSp delSp modSp new mod">
        <pc:chgData name="Song, Ziliang" userId="81d16429-0f9a-4185-9336-86602ad2fda1" providerId="ADAL" clId="{01877568-1086-49AD-8E62-3486DBC9DE55}" dt="2023-01-19T08:14:13.704" v="869" actId="1076"/>
        <pc:sldMkLst>
          <pc:docMk/>
          <pc:sldMk cId="2340565218" sldId="256"/>
        </pc:sldMkLst>
        <pc:spChg chg="del">
          <ac:chgData name="Song, Ziliang" userId="81d16429-0f9a-4185-9336-86602ad2fda1" providerId="ADAL" clId="{01877568-1086-49AD-8E62-3486DBC9DE55}" dt="2023-01-17T16:07:17.217" v="1" actId="478"/>
          <ac:spMkLst>
            <pc:docMk/>
            <pc:sldMk cId="2340565218" sldId="256"/>
            <ac:spMk id="2" creationId="{2B5F6302-6B09-865F-8C36-2548D37BB1F5}"/>
          </ac:spMkLst>
        </pc:spChg>
        <pc:spChg chg="add mod">
          <ac:chgData name="Song, Ziliang" userId="81d16429-0f9a-4185-9336-86602ad2fda1" providerId="ADAL" clId="{01877568-1086-49AD-8E62-3486DBC9DE55}" dt="2023-01-19T08:14:13.704" v="869" actId="1076"/>
          <ac:spMkLst>
            <pc:docMk/>
            <pc:sldMk cId="2340565218" sldId="256"/>
            <ac:spMk id="2" creationId="{4212C1FF-725C-7428-D455-1C097F03105A}"/>
          </ac:spMkLst>
        </pc:spChg>
        <pc:spChg chg="del">
          <ac:chgData name="Song, Ziliang" userId="81d16429-0f9a-4185-9336-86602ad2fda1" providerId="ADAL" clId="{01877568-1086-49AD-8E62-3486DBC9DE55}" dt="2023-01-17T16:07:17.217" v="1" actId="478"/>
          <ac:spMkLst>
            <pc:docMk/>
            <pc:sldMk cId="2340565218" sldId="256"/>
            <ac:spMk id="3" creationId="{84D2E556-EFC8-CAF8-BBE9-5F28BFF4000A}"/>
          </ac:spMkLst>
        </pc:spChg>
        <pc:spChg chg="add del">
          <ac:chgData name="Song, Ziliang" userId="81d16429-0f9a-4185-9336-86602ad2fda1" providerId="ADAL" clId="{01877568-1086-49AD-8E62-3486DBC9DE55}" dt="2023-01-17T16:07:38.704" v="4"/>
          <ac:spMkLst>
            <pc:docMk/>
            <pc:sldMk cId="2340565218" sldId="256"/>
            <ac:spMk id="4" creationId="{64990B4B-74AF-CC1A-4973-AE8754083669}"/>
          </ac:spMkLst>
        </pc:spChg>
        <pc:spChg chg="add del">
          <ac:chgData name="Song, Ziliang" userId="81d16429-0f9a-4185-9336-86602ad2fda1" providerId="ADAL" clId="{01877568-1086-49AD-8E62-3486DBC9DE55}" dt="2023-01-18T04:40:54.104" v="419"/>
          <ac:spMkLst>
            <pc:docMk/>
            <pc:sldMk cId="2340565218" sldId="256"/>
            <ac:spMk id="6" creationId="{401A8655-3BCC-360D-10D7-AEF7D7351932}"/>
          </ac:spMkLst>
        </pc:spChg>
        <pc:picChg chg="add del mod modCrop">
          <ac:chgData name="Song, Ziliang" userId="81d16429-0f9a-4185-9336-86602ad2fda1" providerId="ADAL" clId="{01877568-1086-49AD-8E62-3486DBC9DE55}" dt="2023-01-18T04:40:51.342" v="417" actId="478"/>
          <ac:picMkLst>
            <pc:docMk/>
            <pc:sldMk cId="2340565218" sldId="256"/>
            <ac:picMk id="5" creationId="{59630377-51AE-2AD2-E53E-3F8CA63FD6A8}"/>
          </ac:picMkLst>
        </pc:picChg>
        <pc:picChg chg="add del mod modCrop">
          <ac:chgData name="Song, Ziliang" userId="81d16429-0f9a-4185-9336-86602ad2fda1" providerId="ADAL" clId="{01877568-1086-49AD-8E62-3486DBC9DE55}" dt="2023-01-18T05:57:35.675" v="447" actId="478"/>
          <ac:picMkLst>
            <pc:docMk/>
            <pc:sldMk cId="2340565218" sldId="256"/>
            <ac:picMk id="7" creationId="{D87443AF-0EFA-8C6C-5027-3FE731916DC5}"/>
          </ac:picMkLst>
        </pc:picChg>
        <pc:picChg chg="add mod modCrop">
          <ac:chgData name="Song, Ziliang" userId="81d16429-0f9a-4185-9336-86602ad2fda1" providerId="ADAL" clId="{01877568-1086-49AD-8E62-3486DBC9DE55}" dt="2023-01-18T05:58:14.777" v="455" actId="1076"/>
          <ac:picMkLst>
            <pc:docMk/>
            <pc:sldMk cId="2340565218" sldId="256"/>
            <ac:picMk id="8" creationId="{290F0489-715A-7891-6151-1381A048720E}"/>
          </ac:picMkLst>
        </pc:picChg>
      </pc:sldChg>
      <pc:sldChg chg="addSp delSp modSp add mod ord">
        <pc:chgData name="Song, Ziliang" userId="81d16429-0f9a-4185-9336-86602ad2fda1" providerId="ADAL" clId="{01877568-1086-49AD-8E62-3486DBC9DE55}" dt="2023-01-19T08:14:34.387" v="879" actId="20577"/>
        <pc:sldMkLst>
          <pc:docMk/>
          <pc:sldMk cId="113164147" sldId="257"/>
        </pc:sldMkLst>
        <pc:spChg chg="add del">
          <ac:chgData name="Song, Ziliang" userId="81d16429-0f9a-4185-9336-86602ad2fda1" providerId="ADAL" clId="{01877568-1086-49AD-8E62-3486DBC9DE55}" dt="2023-01-17T17:08:05.346" v="17"/>
          <ac:spMkLst>
            <pc:docMk/>
            <pc:sldMk cId="113164147" sldId="257"/>
            <ac:spMk id="2" creationId="{E9199F00-2105-BBBC-C406-F2BF401ADF16}"/>
          </ac:spMkLst>
        </pc:spChg>
        <pc:spChg chg="add mod">
          <ac:chgData name="Song, Ziliang" userId="81d16429-0f9a-4185-9336-86602ad2fda1" providerId="ADAL" clId="{01877568-1086-49AD-8E62-3486DBC9DE55}" dt="2023-01-19T08:14:34.387" v="879" actId="20577"/>
          <ac:spMkLst>
            <pc:docMk/>
            <pc:sldMk cId="113164147" sldId="257"/>
            <ac:spMk id="2" creationId="{ED0F2212-3CF0-00F3-3830-FD677E944BBF}"/>
          </ac:spMkLst>
        </pc:spChg>
        <pc:spChg chg="add mod ord topLvl">
          <ac:chgData name="Song, Ziliang" userId="81d16429-0f9a-4185-9336-86602ad2fda1" providerId="ADAL" clId="{01877568-1086-49AD-8E62-3486DBC9DE55}" dt="2023-01-18T08:30:50.272" v="605" actId="14100"/>
          <ac:spMkLst>
            <pc:docMk/>
            <pc:sldMk cId="113164147" sldId="257"/>
            <ac:spMk id="15" creationId="{036F0DAA-EA07-578B-65C4-9B3328888164}"/>
          </ac:spMkLst>
        </pc:spChg>
        <pc:spChg chg="add del mod">
          <ac:chgData name="Song, Ziliang" userId="81d16429-0f9a-4185-9336-86602ad2fda1" providerId="ADAL" clId="{01877568-1086-49AD-8E62-3486DBC9DE55}" dt="2023-01-18T03:47:34.302" v="276"/>
          <ac:spMkLst>
            <pc:docMk/>
            <pc:sldMk cId="113164147" sldId="257"/>
            <ac:spMk id="16" creationId="{BB64BA5C-4725-9E08-6CF1-57052C328005}"/>
          </ac:spMkLst>
        </pc:spChg>
        <pc:spChg chg="add mod topLvl">
          <ac:chgData name="Song, Ziliang" userId="81d16429-0f9a-4185-9336-86602ad2fda1" providerId="ADAL" clId="{01877568-1086-49AD-8E62-3486DBC9DE55}" dt="2023-01-18T08:33:00.838" v="628" actId="1076"/>
          <ac:spMkLst>
            <pc:docMk/>
            <pc:sldMk cId="113164147" sldId="257"/>
            <ac:spMk id="17" creationId="{F78F3A46-7273-B705-0EE0-9E4973EB412F}"/>
          </ac:spMkLst>
        </pc:spChg>
        <pc:spChg chg="add mod topLvl">
          <ac:chgData name="Song, Ziliang" userId="81d16429-0f9a-4185-9336-86602ad2fda1" providerId="ADAL" clId="{01877568-1086-49AD-8E62-3486DBC9DE55}" dt="2023-01-18T08:31:42.621" v="615" actId="14100"/>
          <ac:spMkLst>
            <pc:docMk/>
            <pc:sldMk cId="113164147" sldId="257"/>
            <ac:spMk id="18" creationId="{3DF47C10-A10B-8FF2-E952-C64A912CB3A2}"/>
          </ac:spMkLst>
        </pc:spChg>
        <pc:spChg chg="add mod topLvl">
          <ac:chgData name="Song, Ziliang" userId="81d16429-0f9a-4185-9336-86602ad2fda1" providerId="ADAL" clId="{01877568-1086-49AD-8E62-3486DBC9DE55}" dt="2023-01-18T08:32:53.677" v="627" actId="1076"/>
          <ac:spMkLst>
            <pc:docMk/>
            <pc:sldMk cId="113164147" sldId="257"/>
            <ac:spMk id="19" creationId="{CD9E9B2B-1705-7531-940B-B6A5332BA1D8}"/>
          </ac:spMkLst>
        </pc:spChg>
        <pc:spChg chg="add mod topLvl">
          <ac:chgData name="Song, Ziliang" userId="81d16429-0f9a-4185-9336-86602ad2fda1" providerId="ADAL" clId="{01877568-1086-49AD-8E62-3486DBC9DE55}" dt="2023-01-18T08:32:03.593" v="620" actId="14100"/>
          <ac:spMkLst>
            <pc:docMk/>
            <pc:sldMk cId="113164147" sldId="257"/>
            <ac:spMk id="20" creationId="{0A802746-33E3-C915-398C-C35D497F00F2}"/>
          </ac:spMkLst>
        </pc:spChg>
        <pc:spChg chg="add mod topLvl">
          <ac:chgData name="Song, Ziliang" userId="81d16429-0f9a-4185-9336-86602ad2fda1" providerId="ADAL" clId="{01877568-1086-49AD-8E62-3486DBC9DE55}" dt="2023-01-18T08:32:47.461" v="626" actId="1076"/>
          <ac:spMkLst>
            <pc:docMk/>
            <pc:sldMk cId="113164147" sldId="257"/>
            <ac:spMk id="21" creationId="{08735AFA-D780-2363-12C7-62272B9F806F}"/>
          </ac:spMkLst>
        </pc:spChg>
        <pc:spChg chg="add mod topLvl">
          <ac:chgData name="Song, Ziliang" userId="81d16429-0f9a-4185-9336-86602ad2fda1" providerId="ADAL" clId="{01877568-1086-49AD-8E62-3486DBC9DE55}" dt="2023-01-18T08:32:32.109" v="624" actId="14100"/>
          <ac:spMkLst>
            <pc:docMk/>
            <pc:sldMk cId="113164147" sldId="257"/>
            <ac:spMk id="22" creationId="{5D0B1245-0232-5057-270B-829F3895312F}"/>
          </ac:spMkLst>
        </pc:spChg>
        <pc:spChg chg="add mod topLvl">
          <ac:chgData name="Song, Ziliang" userId="81d16429-0f9a-4185-9336-86602ad2fda1" providerId="ADAL" clId="{01877568-1086-49AD-8E62-3486DBC9DE55}" dt="2023-01-18T08:32:40.346" v="625" actId="1076"/>
          <ac:spMkLst>
            <pc:docMk/>
            <pc:sldMk cId="113164147" sldId="257"/>
            <ac:spMk id="23" creationId="{5234ACA6-66CA-7574-7503-7D293F92179C}"/>
          </ac:spMkLst>
        </pc:spChg>
        <pc:spChg chg="add del">
          <ac:chgData name="Song, Ziliang" userId="81d16429-0f9a-4185-9336-86602ad2fda1" providerId="ADAL" clId="{01877568-1086-49AD-8E62-3486DBC9DE55}" dt="2023-01-18T08:25:46.623" v="459"/>
          <ac:spMkLst>
            <pc:docMk/>
            <pc:sldMk cId="113164147" sldId="257"/>
            <ac:spMk id="25" creationId="{A7551F16-11C1-E7E4-A012-97C7EAA8779E}"/>
          </ac:spMkLst>
        </pc:spChg>
        <pc:grpChg chg="add del mod">
          <ac:chgData name="Song, Ziliang" userId="81d16429-0f9a-4185-9336-86602ad2fda1" providerId="ADAL" clId="{01877568-1086-49AD-8E62-3486DBC9DE55}" dt="2023-01-18T08:25:38.093" v="456" actId="165"/>
          <ac:grpSpMkLst>
            <pc:docMk/>
            <pc:sldMk cId="113164147" sldId="257"/>
            <ac:grpSpMk id="24" creationId="{3983A066-F65E-1C48-9AB3-F12E7234C94F}"/>
          </ac:grpSpMkLst>
        </pc:grpChg>
        <pc:picChg chg="add del mod topLvl modCrop">
          <ac:chgData name="Song, Ziliang" userId="81d16429-0f9a-4185-9336-86602ad2fda1" providerId="ADAL" clId="{01877568-1086-49AD-8E62-3486DBC9DE55}" dt="2023-01-18T08:25:42.297" v="457" actId="478"/>
          <ac:picMkLst>
            <pc:docMk/>
            <pc:sldMk cId="113164147" sldId="257"/>
            <ac:picMk id="3" creationId="{62D4EBB2-B8E1-EF61-C28A-CB6615EC1064}"/>
          </ac:picMkLst>
        </pc:picChg>
        <pc:picChg chg="del">
          <ac:chgData name="Song, Ziliang" userId="81d16429-0f9a-4185-9336-86602ad2fda1" providerId="ADAL" clId="{01877568-1086-49AD-8E62-3486DBC9DE55}" dt="2023-01-17T16:07:57.013" v="7" actId="478"/>
          <ac:picMkLst>
            <pc:docMk/>
            <pc:sldMk cId="113164147" sldId="257"/>
            <ac:picMk id="5" creationId="{59630377-51AE-2AD2-E53E-3F8CA63FD6A8}"/>
          </ac:picMkLst>
        </pc:picChg>
        <pc:picChg chg="add mod ord modCrop">
          <ac:chgData name="Song, Ziliang" userId="81d16429-0f9a-4185-9336-86602ad2fda1" providerId="ADAL" clId="{01877568-1086-49AD-8E62-3486DBC9DE55}" dt="2023-01-18T08:28:05.232" v="511" actId="12789"/>
          <ac:picMkLst>
            <pc:docMk/>
            <pc:sldMk cId="113164147" sldId="257"/>
            <ac:picMk id="26" creationId="{878FF062-2976-46B2-BC25-8A959565BDBC}"/>
          </ac:picMkLst>
        </pc:picChg>
        <pc:cxnChg chg="add mod topLvl">
          <ac:chgData name="Song, Ziliang" userId="81d16429-0f9a-4185-9336-86602ad2fda1" providerId="ADAL" clId="{01877568-1086-49AD-8E62-3486DBC9DE55}" dt="2023-01-18T08:28:39.215" v="516" actId="14100"/>
          <ac:cxnSpMkLst>
            <pc:docMk/>
            <pc:sldMk cId="113164147" sldId="257"/>
            <ac:cxnSpMk id="6" creationId="{935832D7-7E81-CCCB-ED47-A5A3B1CDFCA8}"/>
          </ac:cxnSpMkLst>
        </pc:cxnChg>
        <pc:cxnChg chg="add mod topLvl">
          <ac:chgData name="Song, Ziliang" userId="81d16429-0f9a-4185-9336-86602ad2fda1" providerId="ADAL" clId="{01877568-1086-49AD-8E62-3486DBC9DE55}" dt="2023-01-18T08:29:13.080" v="534" actId="14100"/>
          <ac:cxnSpMkLst>
            <pc:docMk/>
            <pc:sldMk cId="113164147" sldId="257"/>
            <ac:cxnSpMk id="9" creationId="{BC8F7CE8-70A2-7997-FECC-D30686168609}"/>
          </ac:cxnSpMkLst>
        </pc:cxnChg>
        <pc:cxnChg chg="add mod topLvl">
          <ac:chgData name="Song, Ziliang" userId="81d16429-0f9a-4185-9336-86602ad2fda1" providerId="ADAL" clId="{01877568-1086-49AD-8E62-3486DBC9DE55}" dt="2023-01-18T08:29:41.743" v="559" actId="14100"/>
          <ac:cxnSpMkLst>
            <pc:docMk/>
            <pc:sldMk cId="113164147" sldId="257"/>
            <ac:cxnSpMk id="10" creationId="{C151086A-0DE5-46DE-4E12-39CC42298B81}"/>
          </ac:cxnSpMkLst>
        </pc:cxnChg>
        <pc:cxnChg chg="add mod topLvl">
          <ac:chgData name="Song, Ziliang" userId="81d16429-0f9a-4185-9336-86602ad2fda1" providerId="ADAL" clId="{01877568-1086-49AD-8E62-3486DBC9DE55}" dt="2023-01-18T08:30:31.479" v="602" actId="14100"/>
          <ac:cxnSpMkLst>
            <pc:docMk/>
            <pc:sldMk cId="113164147" sldId="257"/>
            <ac:cxnSpMk id="11" creationId="{048DA648-8E4C-D82B-493C-9938E81215E8}"/>
          </ac:cxnSpMkLst>
        </pc:cxnChg>
        <pc:cxnChg chg="add mod topLvl">
          <ac:chgData name="Song, Ziliang" userId="81d16429-0f9a-4185-9336-86602ad2fda1" providerId="ADAL" clId="{01877568-1086-49AD-8E62-3486DBC9DE55}" dt="2023-01-18T08:34:18.287" v="630" actId="208"/>
          <ac:cxnSpMkLst>
            <pc:docMk/>
            <pc:sldMk cId="113164147" sldId="257"/>
            <ac:cxnSpMk id="13" creationId="{B6B288FA-9EF3-5B87-70BC-7CD1D486FD07}"/>
          </ac:cxnSpMkLst>
        </pc:cxnChg>
        <pc:cxnChg chg="add mod topLvl">
          <ac:chgData name="Song, Ziliang" userId="81d16429-0f9a-4185-9336-86602ad2fda1" providerId="ADAL" clId="{01877568-1086-49AD-8E62-3486DBC9DE55}" dt="2023-01-18T08:30:00.653" v="583" actId="14100"/>
          <ac:cxnSpMkLst>
            <pc:docMk/>
            <pc:sldMk cId="113164147" sldId="257"/>
            <ac:cxnSpMk id="14" creationId="{F9967E0F-E489-B79F-E3D3-DB8E2039C30A}"/>
          </ac:cxnSpMkLst>
        </pc:cxnChg>
      </pc:sldChg>
      <pc:sldChg chg="addSp delSp modSp add mod ord">
        <pc:chgData name="Song, Ziliang" userId="81d16429-0f9a-4185-9336-86602ad2fda1" providerId="ADAL" clId="{01877568-1086-49AD-8E62-3486DBC9DE55}" dt="2023-01-19T08:15:27.782" v="888" actId="20577"/>
        <pc:sldMkLst>
          <pc:docMk/>
          <pc:sldMk cId="1498467712" sldId="258"/>
        </pc:sldMkLst>
        <pc:spChg chg="add mod">
          <ac:chgData name="Song, Ziliang" userId="81d16429-0f9a-4185-9336-86602ad2fda1" providerId="ADAL" clId="{01877568-1086-49AD-8E62-3486DBC9DE55}" dt="2023-01-19T08:15:27.782" v="888" actId="20577"/>
          <ac:spMkLst>
            <pc:docMk/>
            <pc:sldMk cId="1498467712" sldId="258"/>
            <ac:spMk id="2" creationId="{693B6982-3461-7AEB-A530-9272B9C3E940}"/>
          </ac:spMkLst>
        </pc:spChg>
        <pc:spChg chg="add del">
          <ac:chgData name="Song, Ziliang" userId="81d16429-0f9a-4185-9336-86602ad2fda1" providerId="ADAL" clId="{01877568-1086-49AD-8E62-3486DBC9DE55}" dt="2023-01-18T04:33:46.559" v="402"/>
          <ac:spMkLst>
            <pc:docMk/>
            <pc:sldMk cId="1498467712" sldId="258"/>
            <ac:spMk id="2" creationId="{9B1C47A5-E608-22AC-0FB4-818059ABFF02}"/>
          </ac:spMkLst>
        </pc:spChg>
        <pc:spChg chg="add del">
          <ac:chgData name="Song, Ziliang" userId="81d16429-0f9a-4185-9336-86602ad2fda1" providerId="ADAL" clId="{01877568-1086-49AD-8E62-3486DBC9DE55}" dt="2023-01-18T08:57:01.731" v="795"/>
          <ac:spMkLst>
            <pc:docMk/>
            <pc:sldMk cId="1498467712" sldId="258"/>
            <ac:spMk id="4" creationId="{BEA0B9DC-DCC1-BD78-970B-27121731BF21}"/>
          </ac:spMkLst>
        </pc:spChg>
        <pc:picChg chg="add del mod modCrop">
          <ac:chgData name="Song, Ziliang" userId="81d16429-0f9a-4185-9336-86602ad2fda1" providerId="ADAL" clId="{01877568-1086-49AD-8E62-3486DBC9DE55}" dt="2023-01-18T08:56:58.547" v="793" actId="478"/>
          <ac:picMkLst>
            <pc:docMk/>
            <pc:sldMk cId="1498467712" sldId="258"/>
            <ac:picMk id="3" creationId="{3A1F9FC6-A4A0-D2BF-7C40-DFD39AC663F9}"/>
          </ac:picMkLst>
        </pc:picChg>
        <pc:picChg chg="add mod modCrop">
          <ac:chgData name="Song, Ziliang" userId="81d16429-0f9a-4185-9336-86602ad2fda1" providerId="ADAL" clId="{01877568-1086-49AD-8E62-3486DBC9DE55}" dt="2023-01-18T08:57:28.609" v="803" actId="1076"/>
          <ac:picMkLst>
            <pc:docMk/>
            <pc:sldMk cId="1498467712" sldId="258"/>
            <ac:picMk id="5" creationId="{53DA2083-2018-E7A0-9DB9-296E1F71B143}"/>
          </ac:picMkLst>
        </pc:picChg>
      </pc:sldChg>
      <pc:sldChg chg="addSp delSp modSp add mod">
        <pc:chgData name="Song, Ziliang" userId="81d16429-0f9a-4185-9336-86602ad2fda1" providerId="ADAL" clId="{01877568-1086-49AD-8E62-3486DBC9DE55}" dt="2023-01-19T08:14:18.917" v="871" actId="20577"/>
        <pc:sldMkLst>
          <pc:docMk/>
          <pc:sldMk cId="2753348551" sldId="259"/>
        </pc:sldMkLst>
        <pc:spChg chg="add mod">
          <ac:chgData name="Song, Ziliang" userId="81d16429-0f9a-4185-9336-86602ad2fda1" providerId="ADAL" clId="{01877568-1086-49AD-8E62-3486DBC9DE55}" dt="2023-01-19T08:14:18.917" v="871" actId="20577"/>
          <ac:spMkLst>
            <pc:docMk/>
            <pc:sldMk cId="2753348551" sldId="259"/>
            <ac:spMk id="2" creationId="{70BA15E2-FC30-3853-AB08-834E07CD1318}"/>
          </ac:spMkLst>
        </pc:spChg>
        <pc:spChg chg="add del">
          <ac:chgData name="Song, Ziliang" userId="81d16429-0f9a-4185-9336-86602ad2fda1" providerId="ADAL" clId="{01877568-1086-49AD-8E62-3486DBC9DE55}" dt="2023-01-18T05:31:06.523" v="429"/>
          <ac:spMkLst>
            <pc:docMk/>
            <pc:sldMk cId="2753348551" sldId="259"/>
            <ac:spMk id="2" creationId="{CEA4C25A-2E31-11BB-5DE2-20E48A0E1C9C}"/>
          </ac:spMkLst>
        </pc:spChg>
        <pc:spChg chg="add del">
          <ac:chgData name="Song, Ziliang" userId="81d16429-0f9a-4185-9336-86602ad2fda1" providerId="ADAL" clId="{01877568-1086-49AD-8E62-3486DBC9DE55}" dt="2023-01-18T05:32:03.243" v="435"/>
          <ac:spMkLst>
            <pc:docMk/>
            <pc:sldMk cId="2753348551" sldId="259"/>
            <ac:spMk id="4" creationId="{19D9174F-F31E-D96E-E85E-AF0F9FD39EAC}"/>
          </ac:spMkLst>
        </pc:spChg>
        <pc:spChg chg="add del">
          <ac:chgData name="Song, Ziliang" userId="81d16429-0f9a-4185-9336-86602ad2fda1" providerId="ADAL" clId="{01877568-1086-49AD-8E62-3486DBC9DE55}" dt="2023-01-18T05:33:49.234" v="443"/>
          <ac:spMkLst>
            <pc:docMk/>
            <pc:sldMk cId="2753348551" sldId="259"/>
            <ac:spMk id="6" creationId="{498DE49C-6F8C-F901-E1C9-EE523493FE26}"/>
          </ac:spMkLst>
        </pc:spChg>
        <pc:picChg chg="add del mod modCrop">
          <ac:chgData name="Song, Ziliang" userId="81d16429-0f9a-4185-9336-86602ad2fda1" providerId="ADAL" clId="{01877568-1086-49AD-8E62-3486DBC9DE55}" dt="2023-01-18T05:33:45.748" v="440" actId="478"/>
          <ac:picMkLst>
            <pc:docMk/>
            <pc:sldMk cId="2753348551" sldId="259"/>
            <ac:picMk id="3" creationId="{6647CB40-86D7-8687-EA48-F90B4C7F761E}"/>
          </ac:picMkLst>
        </pc:picChg>
        <pc:picChg chg="add del mod modCrop">
          <ac:chgData name="Song, Ziliang" userId="81d16429-0f9a-4185-9336-86602ad2fda1" providerId="ADAL" clId="{01877568-1086-49AD-8E62-3486DBC9DE55}" dt="2023-01-18T05:33:46.465" v="441" actId="478"/>
          <ac:picMkLst>
            <pc:docMk/>
            <pc:sldMk cId="2753348551" sldId="259"/>
            <ac:picMk id="5" creationId="{92336A83-90A7-49BE-BB64-617B2C0F9176}"/>
          </ac:picMkLst>
        </pc:picChg>
        <pc:picChg chg="add del mod modCrop">
          <ac:chgData name="Song, Ziliang" userId="81d16429-0f9a-4185-9336-86602ad2fda1" providerId="ADAL" clId="{01877568-1086-49AD-8E62-3486DBC9DE55}" dt="2023-01-18T09:48:56.845" v="841" actId="478"/>
          <ac:picMkLst>
            <pc:docMk/>
            <pc:sldMk cId="2753348551" sldId="259"/>
            <ac:picMk id="7" creationId="{D69BB735-DA4A-B995-C1AC-0A08A988488B}"/>
          </ac:picMkLst>
        </pc:picChg>
        <pc:picChg chg="add del mod modCrop">
          <ac:chgData name="Song, Ziliang" userId="81d16429-0f9a-4185-9336-86602ad2fda1" providerId="ADAL" clId="{01877568-1086-49AD-8E62-3486DBC9DE55}" dt="2023-01-18T09:49:45.105" v="847" actId="478"/>
          <ac:picMkLst>
            <pc:docMk/>
            <pc:sldMk cId="2753348551" sldId="259"/>
            <ac:picMk id="8" creationId="{CFBE7C11-CEB9-8406-BB78-F3BDE3712DF6}"/>
          </ac:picMkLst>
        </pc:picChg>
        <pc:picChg chg="add mod modCrop">
          <ac:chgData name="Song, Ziliang" userId="81d16429-0f9a-4185-9336-86602ad2fda1" providerId="ADAL" clId="{01877568-1086-49AD-8E62-3486DBC9DE55}" dt="2023-01-18T09:50:15.620" v="855" actId="1076"/>
          <ac:picMkLst>
            <pc:docMk/>
            <pc:sldMk cId="2753348551" sldId="259"/>
            <ac:picMk id="9" creationId="{2220F4B5-82EF-9314-B56C-84B699F09A28}"/>
          </ac:picMkLst>
        </pc:picChg>
      </pc:sldChg>
      <pc:sldChg chg="addSp delSp modSp add mod ord">
        <pc:chgData name="Song, Ziliang" userId="81d16429-0f9a-4185-9336-86602ad2fda1" providerId="ADAL" clId="{01877568-1086-49AD-8E62-3486DBC9DE55}" dt="2023-01-19T08:15:24.856" v="887" actId="20577"/>
        <pc:sldMkLst>
          <pc:docMk/>
          <pc:sldMk cId="2675529939" sldId="260"/>
        </pc:sldMkLst>
        <pc:spChg chg="add del">
          <ac:chgData name="Song, Ziliang" userId="81d16429-0f9a-4185-9336-86602ad2fda1" providerId="ADAL" clId="{01877568-1086-49AD-8E62-3486DBC9DE55}" dt="2023-01-18T08:39:48.198" v="632"/>
          <ac:spMkLst>
            <pc:docMk/>
            <pc:sldMk cId="2675529939" sldId="260"/>
            <ac:spMk id="2" creationId="{48727426-7477-3E78-5E22-4E024F267156}"/>
          </ac:spMkLst>
        </pc:spChg>
        <pc:spChg chg="add mod">
          <ac:chgData name="Song, Ziliang" userId="81d16429-0f9a-4185-9336-86602ad2fda1" providerId="ADAL" clId="{01877568-1086-49AD-8E62-3486DBC9DE55}" dt="2023-01-19T08:15:24.856" v="887" actId="20577"/>
          <ac:spMkLst>
            <pc:docMk/>
            <pc:sldMk cId="2675529939" sldId="260"/>
            <ac:spMk id="2" creationId="{855795BF-F9CC-3E8B-2654-7B45AF43CDFF}"/>
          </ac:spMkLst>
        </pc:spChg>
        <pc:spChg chg="add mod">
          <ac:chgData name="Song, Ziliang" userId="81d16429-0f9a-4185-9336-86602ad2fda1" providerId="ADAL" clId="{01877568-1086-49AD-8E62-3486DBC9DE55}" dt="2023-01-18T08:48:11.929" v="715" actId="14100"/>
          <ac:spMkLst>
            <pc:docMk/>
            <pc:sldMk cId="2675529939" sldId="260"/>
            <ac:spMk id="10" creationId="{C45BF706-2430-0C06-CE73-5EEDBC81E11F}"/>
          </ac:spMkLst>
        </pc:spChg>
        <pc:spChg chg="add mod">
          <ac:chgData name="Song, Ziliang" userId="81d16429-0f9a-4185-9336-86602ad2fda1" providerId="ADAL" clId="{01877568-1086-49AD-8E62-3486DBC9DE55}" dt="2023-01-18T08:48:26.607" v="729" actId="20577"/>
          <ac:spMkLst>
            <pc:docMk/>
            <pc:sldMk cId="2675529939" sldId="260"/>
            <ac:spMk id="11" creationId="{C7AC0711-0AD6-4319-3831-7B82140573BF}"/>
          </ac:spMkLst>
        </pc:spChg>
        <pc:spChg chg="add mod">
          <ac:chgData name="Song, Ziliang" userId="81d16429-0f9a-4185-9336-86602ad2fda1" providerId="ADAL" clId="{01877568-1086-49AD-8E62-3486DBC9DE55}" dt="2023-01-18T08:49:10.521" v="739" actId="14100"/>
          <ac:spMkLst>
            <pc:docMk/>
            <pc:sldMk cId="2675529939" sldId="260"/>
            <ac:spMk id="12" creationId="{2A560857-23AD-DCAC-BEA8-B061CDD2DD96}"/>
          </ac:spMkLst>
        </pc:spChg>
        <pc:spChg chg="add mod">
          <ac:chgData name="Song, Ziliang" userId="81d16429-0f9a-4185-9336-86602ad2fda1" providerId="ADAL" clId="{01877568-1086-49AD-8E62-3486DBC9DE55}" dt="2023-01-18T08:49:42.719" v="761" actId="1035"/>
          <ac:spMkLst>
            <pc:docMk/>
            <pc:sldMk cId="2675529939" sldId="260"/>
            <ac:spMk id="13" creationId="{E3BD07EF-99B6-05B8-52A6-AD00C1EFA991}"/>
          </ac:spMkLst>
        </pc:spChg>
        <pc:spChg chg="add mod">
          <ac:chgData name="Song, Ziliang" userId="81d16429-0f9a-4185-9336-86602ad2fda1" providerId="ADAL" clId="{01877568-1086-49AD-8E62-3486DBC9DE55}" dt="2023-01-18T08:50:46.470" v="775" actId="14100"/>
          <ac:spMkLst>
            <pc:docMk/>
            <pc:sldMk cId="2675529939" sldId="260"/>
            <ac:spMk id="14" creationId="{5CD02E59-C032-4EE4-34F1-9434D84EFF56}"/>
          </ac:spMkLst>
        </pc:spChg>
        <pc:spChg chg="add mod">
          <ac:chgData name="Song, Ziliang" userId="81d16429-0f9a-4185-9336-86602ad2fda1" providerId="ADAL" clId="{01877568-1086-49AD-8E62-3486DBC9DE55}" dt="2023-01-18T08:51:16.970" v="792" actId="1038"/>
          <ac:spMkLst>
            <pc:docMk/>
            <pc:sldMk cId="2675529939" sldId="260"/>
            <ac:spMk id="15" creationId="{9D6125A9-29DD-27B4-0AA4-E841F2715242}"/>
          </ac:spMkLst>
        </pc:spChg>
        <pc:picChg chg="add mod modCrop">
          <ac:chgData name="Song, Ziliang" userId="81d16429-0f9a-4185-9336-86602ad2fda1" providerId="ADAL" clId="{01877568-1086-49AD-8E62-3486DBC9DE55}" dt="2023-01-18T08:40:21.697" v="642" actId="1076"/>
          <ac:picMkLst>
            <pc:docMk/>
            <pc:sldMk cId="2675529939" sldId="260"/>
            <ac:picMk id="3" creationId="{52B978B2-01B6-F079-0F40-6A44CCF937AA}"/>
          </ac:picMkLst>
        </pc:picChg>
        <pc:cxnChg chg="add mod">
          <ac:chgData name="Song, Ziliang" userId="81d16429-0f9a-4185-9336-86602ad2fda1" providerId="ADAL" clId="{01877568-1086-49AD-8E62-3486DBC9DE55}" dt="2023-01-18T08:47:13.132" v="705" actId="1035"/>
          <ac:cxnSpMkLst>
            <pc:docMk/>
            <pc:sldMk cId="2675529939" sldId="260"/>
            <ac:cxnSpMk id="4" creationId="{41BF29EE-1593-ED35-8FF9-15CBDE29EBF3}"/>
          </ac:cxnSpMkLst>
        </pc:cxnChg>
        <pc:cxnChg chg="add mod">
          <ac:chgData name="Song, Ziliang" userId="81d16429-0f9a-4185-9336-86602ad2fda1" providerId="ADAL" clId="{01877568-1086-49AD-8E62-3486DBC9DE55}" dt="2023-01-18T08:46:25.945" v="649" actId="1036"/>
          <ac:cxnSpMkLst>
            <pc:docMk/>
            <pc:sldMk cId="2675529939" sldId="260"/>
            <ac:cxnSpMk id="5" creationId="{41CB61F7-7956-36D2-B84A-0923A0EB4893}"/>
          </ac:cxnSpMkLst>
        </pc:cxnChg>
        <pc:cxnChg chg="add mod">
          <ac:chgData name="Song, Ziliang" userId="81d16429-0f9a-4185-9336-86602ad2fda1" providerId="ADAL" clId="{01877568-1086-49AD-8E62-3486DBC9DE55}" dt="2023-01-18T08:46:45.306" v="664" actId="1038"/>
          <ac:cxnSpMkLst>
            <pc:docMk/>
            <pc:sldMk cId="2675529939" sldId="260"/>
            <ac:cxnSpMk id="7" creationId="{6152E609-41A0-22EC-3834-4725D68A1969}"/>
          </ac:cxnSpMkLst>
        </pc:cxnChg>
        <pc:cxnChg chg="add del mod">
          <ac:chgData name="Song, Ziliang" userId="81d16429-0f9a-4185-9336-86602ad2fda1" providerId="ADAL" clId="{01877568-1086-49AD-8E62-3486DBC9DE55}" dt="2023-01-18T08:46:57.668" v="667" actId="478"/>
          <ac:cxnSpMkLst>
            <pc:docMk/>
            <pc:sldMk cId="2675529939" sldId="260"/>
            <ac:cxnSpMk id="8" creationId="{986ECB26-F423-F0AB-0BFE-D37DB1CE47BB}"/>
          </ac:cxnSpMkLst>
        </pc:cxnChg>
        <pc:cxnChg chg="add mod">
          <ac:chgData name="Song, Ziliang" userId="81d16429-0f9a-4185-9336-86602ad2fda1" providerId="ADAL" clId="{01877568-1086-49AD-8E62-3486DBC9DE55}" dt="2023-01-18T08:47:30.935" v="708" actId="1038"/>
          <ac:cxnSpMkLst>
            <pc:docMk/>
            <pc:sldMk cId="2675529939" sldId="260"/>
            <ac:cxnSpMk id="9" creationId="{2FF37CB3-E905-ABA8-7AA4-5B2760098B7B}"/>
          </ac:cxnSpMkLst>
        </pc:cxnChg>
      </pc:sldChg>
      <pc:sldChg chg="addSp delSp modSp add mod ord">
        <pc:chgData name="Song, Ziliang" userId="81d16429-0f9a-4185-9336-86602ad2fda1" providerId="ADAL" clId="{01877568-1086-49AD-8E62-3486DBC9DE55}" dt="2023-01-19T08:14:26.055" v="875" actId="20577"/>
        <pc:sldMkLst>
          <pc:docMk/>
          <pc:sldMk cId="357226950" sldId="261"/>
        </pc:sldMkLst>
        <pc:spChg chg="add mod">
          <ac:chgData name="Song, Ziliang" userId="81d16429-0f9a-4185-9336-86602ad2fda1" providerId="ADAL" clId="{01877568-1086-49AD-8E62-3486DBC9DE55}" dt="2023-01-19T08:14:26.055" v="875" actId="20577"/>
          <ac:spMkLst>
            <pc:docMk/>
            <pc:sldMk cId="357226950" sldId="261"/>
            <ac:spMk id="2" creationId="{2B800F5D-163B-A95B-CF4C-920FA861BD94}"/>
          </ac:spMkLst>
        </pc:spChg>
        <pc:spChg chg="add del">
          <ac:chgData name="Song, Ziliang" userId="81d16429-0f9a-4185-9336-86602ad2fda1" providerId="ADAL" clId="{01877568-1086-49AD-8E62-3486DBC9DE55}" dt="2023-01-18T09:31:07.422" v="805"/>
          <ac:spMkLst>
            <pc:docMk/>
            <pc:sldMk cId="357226950" sldId="261"/>
            <ac:spMk id="2" creationId="{8B7C7D20-F79A-8A50-BEF9-23A5FC2CCCB6}"/>
          </ac:spMkLst>
        </pc:spChg>
        <pc:picChg chg="add mod modCrop">
          <ac:chgData name="Song, Ziliang" userId="81d16429-0f9a-4185-9336-86602ad2fda1" providerId="ADAL" clId="{01877568-1086-49AD-8E62-3486DBC9DE55}" dt="2023-01-18T09:31:35.510" v="813" actId="1076"/>
          <ac:picMkLst>
            <pc:docMk/>
            <pc:sldMk cId="357226950" sldId="261"/>
            <ac:picMk id="3" creationId="{8BCCD411-3808-115B-DD6D-26BF1C815784}"/>
          </ac:picMkLst>
        </pc:picChg>
      </pc:sldChg>
      <pc:sldChg chg="addSp modSp add mod">
        <pc:chgData name="Song, Ziliang" userId="81d16429-0f9a-4185-9336-86602ad2fda1" providerId="ADAL" clId="{01877568-1086-49AD-8E62-3486DBC9DE55}" dt="2023-01-19T08:14:22.728" v="873" actId="20577"/>
        <pc:sldMkLst>
          <pc:docMk/>
          <pc:sldMk cId="1229599793" sldId="262"/>
        </pc:sldMkLst>
        <pc:spChg chg="add mod">
          <ac:chgData name="Song, Ziliang" userId="81d16429-0f9a-4185-9336-86602ad2fda1" providerId="ADAL" clId="{01877568-1086-49AD-8E62-3486DBC9DE55}" dt="2023-01-19T08:14:22.728" v="873" actId="20577"/>
          <ac:spMkLst>
            <pc:docMk/>
            <pc:sldMk cId="1229599793" sldId="262"/>
            <ac:spMk id="3" creationId="{41C9D60A-D47C-72BE-C365-CB44E6AA8D52}"/>
          </ac:spMkLst>
        </pc:spChg>
        <pc:picChg chg="add mod modCrop">
          <ac:chgData name="Song, Ziliang" userId="81d16429-0f9a-4185-9336-86602ad2fda1" providerId="ADAL" clId="{01877568-1086-49AD-8E62-3486DBC9DE55}" dt="2023-01-18T09:40:58.066" v="820" actId="1076"/>
          <ac:picMkLst>
            <pc:docMk/>
            <pc:sldMk cId="1229599793" sldId="262"/>
            <ac:picMk id="2" creationId="{7EF491DE-5B50-CC9A-DA60-57028B7D5284}"/>
          </ac:picMkLst>
        </pc:picChg>
      </pc:sldChg>
      <pc:sldChg chg="addSp delSp modSp add mod">
        <pc:chgData name="Song, Ziliang" userId="81d16429-0f9a-4185-9336-86602ad2fda1" providerId="ADAL" clId="{01877568-1086-49AD-8E62-3486DBC9DE55}" dt="2023-01-19T08:14:29.874" v="877" actId="20577"/>
        <pc:sldMkLst>
          <pc:docMk/>
          <pc:sldMk cId="3077770011" sldId="263"/>
        </pc:sldMkLst>
        <pc:spChg chg="add del">
          <ac:chgData name="Song, Ziliang" userId="81d16429-0f9a-4185-9336-86602ad2fda1" providerId="ADAL" clId="{01877568-1086-49AD-8E62-3486DBC9DE55}" dt="2023-01-18T09:45:22.495" v="822"/>
          <ac:spMkLst>
            <pc:docMk/>
            <pc:sldMk cId="3077770011" sldId="263"/>
            <ac:spMk id="2" creationId="{04844456-0829-9DCD-E656-B5D4A646064C}"/>
          </ac:spMkLst>
        </pc:spChg>
        <pc:spChg chg="add mod">
          <ac:chgData name="Song, Ziliang" userId="81d16429-0f9a-4185-9336-86602ad2fda1" providerId="ADAL" clId="{01877568-1086-49AD-8E62-3486DBC9DE55}" dt="2023-01-19T08:14:29.874" v="877" actId="20577"/>
          <ac:spMkLst>
            <pc:docMk/>
            <pc:sldMk cId="3077770011" sldId="263"/>
            <ac:spMk id="2" creationId="{234B0F0F-7F68-4D1D-5211-AFC62B85FDB0}"/>
          </ac:spMkLst>
        </pc:spChg>
        <pc:picChg chg="add del mod modCrop">
          <ac:chgData name="Song, Ziliang" userId="81d16429-0f9a-4185-9336-86602ad2fda1" providerId="ADAL" clId="{01877568-1086-49AD-8E62-3486DBC9DE55}" dt="2023-01-18T09:51:06.722" v="856" actId="478"/>
          <ac:picMkLst>
            <pc:docMk/>
            <pc:sldMk cId="3077770011" sldId="263"/>
            <ac:picMk id="3" creationId="{F8127BB7-A26A-CEEA-055D-C8561994BD27}"/>
          </ac:picMkLst>
        </pc:picChg>
        <pc:picChg chg="add mod modCrop">
          <ac:chgData name="Song, Ziliang" userId="81d16429-0f9a-4185-9336-86602ad2fda1" providerId="ADAL" clId="{01877568-1086-49AD-8E62-3486DBC9DE55}" dt="2023-01-18T09:51:34.910" v="864" actId="1076"/>
          <ac:picMkLst>
            <pc:docMk/>
            <pc:sldMk cId="3077770011" sldId="263"/>
            <ac:picMk id="4" creationId="{90C3D864-66E5-235E-F60D-97812B682AD6}"/>
          </ac:picMkLst>
        </pc:picChg>
      </pc:sldChg>
      <pc:sldChg chg="add del">
        <pc:chgData name="Song, Ziliang" userId="81d16429-0f9a-4185-9336-86602ad2fda1" providerId="ADAL" clId="{01877568-1086-49AD-8E62-3486DBC9DE55}" dt="2023-01-18T09:46:36.795" v="835" actId="47"/>
        <pc:sldMkLst>
          <pc:docMk/>
          <pc:sldMk cId="2292068971" sldId="264"/>
        </pc:sldMkLst>
      </pc:sldChg>
      <pc:sldChg chg="add del">
        <pc:chgData name="Song, Ziliang" userId="81d16429-0f9a-4185-9336-86602ad2fda1" providerId="ADAL" clId="{01877568-1086-49AD-8E62-3486DBC9DE55}" dt="2023-01-18T09:46:38.318" v="836" actId="47"/>
        <pc:sldMkLst>
          <pc:docMk/>
          <pc:sldMk cId="1020918139" sldId="265"/>
        </pc:sldMkLst>
      </pc:sldChg>
      <pc:sldMasterChg chg="modSp modSldLayout">
        <pc:chgData name="Song, Ziliang" userId="81d16429-0f9a-4185-9336-86602ad2fda1" providerId="ADAL" clId="{01877568-1086-49AD-8E62-3486DBC9DE55}" dt="2023-01-17T16:07:25.709" v="2"/>
        <pc:sldMasterMkLst>
          <pc:docMk/>
          <pc:sldMasterMk cId="2306245397" sldId="2147483648"/>
        </pc:sldMasterMkLst>
        <pc:spChg chg="mod">
          <ac:chgData name="Song, Ziliang" userId="81d16429-0f9a-4185-9336-86602ad2fda1" providerId="ADAL" clId="{01877568-1086-49AD-8E62-3486DBC9DE55}" dt="2023-01-17T16:07:25.709" v="2"/>
          <ac:spMkLst>
            <pc:docMk/>
            <pc:sldMasterMk cId="2306245397" sldId="2147483648"/>
            <ac:spMk id="2" creationId="{3E661CA6-71BF-78B0-4048-F88E10E3B65F}"/>
          </ac:spMkLst>
        </pc:spChg>
        <pc:spChg chg="mod">
          <ac:chgData name="Song, Ziliang" userId="81d16429-0f9a-4185-9336-86602ad2fda1" providerId="ADAL" clId="{01877568-1086-49AD-8E62-3486DBC9DE55}" dt="2023-01-17T16:07:25.709" v="2"/>
          <ac:spMkLst>
            <pc:docMk/>
            <pc:sldMasterMk cId="2306245397" sldId="2147483648"/>
            <ac:spMk id="3" creationId="{4034CD91-1407-00A8-48FC-80B189DC5558}"/>
          </ac:spMkLst>
        </pc:spChg>
        <pc:spChg chg="mod">
          <ac:chgData name="Song, Ziliang" userId="81d16429-0f9a-4185-9336-86602ad2fda1" providerId="ADAL" clId="{01877568-1086-49AD-8E62-3486DBC9DE55}" dt="2023-01-17T16:07:25.709" v="2"/>
          <ac:spMkLst>
            <pc:docMk/>
            <pc:sldMasterMk cId="2306245397" sldId="2147483648"/>
            <ac:spMk id="4" creationId="{2FAE8293-3907-7435-A3DD-6D0F7E67025D}"/>
          </ac:spMkLst>
        </pc:spChg>
        <pc:spChg chg="mod">
          <ac:chgData name="Song, Ziliang" userId="81d16429-0f9a-4185-9336-86602ad2fda1" providerId="ADAL" clId="{01877568-1086-49AD-8E62-3486DBC9DE55}" dt="2023-01-17T16:07:25.709" v="2"/>
          <ac:spMkLst>
            <pc:docMk/>
            <pc:sldMasterMk cId="2306245397" sldId="2147483648"/>
            <ac:spMk id="5" creationId="{CC34EC99-4F7F-07EF-53EC-644B94F4068C}"/>
          </ac:spMkLst>
        </pc:spChg>
        <pc:spChg chg="mod">
          <ac:chgData name="Song, Ziliang" userId="81d16429-0f9a-4185-9336-86602ad2fda1" providerId="ADAL" clId="{01877568-1086-49AD-8E62-3486DBC9DE55}" dt="2023-01-17T16:07:25.709" v="2"/>
          <ac:spMkLst>
            <pc:docMk/>
            <pc:sldMasterMk cId="2306245397" sldId="2147483648"/>
            <ac:spMk id="6" creationId="{A04E6B91-84B2-F8C9-8B1F-195DBCA01019}"/>
          </ac:spMkLst>
        </pc:sp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2129084601" sldId="2147483649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129084601" sldId="2147483649"/>
              <ac:spMk id="2" creationId="{A346721D-91F9-3F87-84CC-75839FA13B71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129084601" sldId="2147483649"/>
              <ac:spMk id="3" creationId="{002EC92D-78AE-D2A9-79B5-2581B6CF358C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2022645562" sldId="2147483651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022645562" sldId="2147483651"/>
              <ac:spMk id="2" creationId="{C57EFD9F-FABA-B298-5B95-387E76745935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022645562" sldId="2147483651"/>
              <ac:spMk id="3" creationId="{F8F7C967-8B4C-4673-529D-7B34DE4E5528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1545070370" sldId="2147483652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1545070370" sldId="2147483652"/>
              <ac:spMk id="3" creationId="{4F34140A-1C21-D5E1-BF3F-1917E74E361F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1545070370" sldId="2147483652"/>
              <ac:spMk id="4" creationId="{FF6C250B-1941-409B-29B7-67A208BFB6BD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2614564855" sldId="2147483653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614564855" sldId="2147483653"/>
              <ac:spMk id="2" creationId="{64EF18D5-4F17-8D07-702D-2E239D476C78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614564855" sldId="2147483653"/>
              <ac:spMk id="3" creationId="{222E4E4E-C46D-A29A-8DBE-465295E576F9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614564855" sldId="2147483653"/>
              <ac:spMk id="4" creationId="{ABE4B55A-D20B-B555-5A5E-8A1FABC56129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614564855" sldId="2147483653"/>
              <ac:spMk id="5" creationId="{85DE98EC-15B9-0BAE-E32E-1E599B114094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2614564855" sldId="2147483653"/>
              <ac:spMk id="6" creationId="{4990E00A-2F85-9B4B-8E54-E9D505E0FD0F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1726238057" sldId="2147483656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1726238057" sldId="2147483656"/>
              <ac:spMk id="2" creationId="{6BC49A18-646B-5A40-3F93-09E0B2A84DF8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1726238057" sldId="2147483656"/>
              <ac:spMk id="3" creationId="{D64874B7-5B4B-A76E-3CA3-8A7B955424CC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1726238057" sldId="2147483656"/>
              <ac:spMk id="4" creationId="{D81460C5-5FFA-78B1-0DAA-3696AD166207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3670713806" sldId="2147483657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3670713806" sldId="2147483657"/>
              <ac:spMk id="2" creationId="{DCBA563A-62C1-761E-1393-65FB880B9372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3670713806" sldId="2147483657"/>
              <ac:spMk id="3" creationId="{98EBBC05-8DB5-6706-D610-55979814D031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3670713806" sldId="2147483657"/>
              <ac:spMk id="4" creationId="{49CDA3FB-4D91-D8B5-BEF2-BC48D03CFDD8}"/>
            </ac:spMkLst>
          </pc:spChg>
        </pc:sldLayoutChg>
        <pc:sldLayoutChg chg="modSp">
          <pc:chgData name="Song, Ziliang" userId="81d16429-0f9a-4185-9336-86602ad2fda1" providerId="ADAL" clId="{01877568-1086-49AD-8E62-3486DBC9DE55}" dt="2023-01-17T16:07:25.709" v="2"/>
          <pc:sldLayoutMkLst>
            <pc:docMk/>
            <pc:sldMasterMk cId="2306245397" sldId="2147483648"/>
            <pc:sldLayoutMk cId="3968457529" sldId="2147483659"/>
          </pc:sldLayoutMkLst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3968457529" sldId="2147483659"/>
              <ac:spMk id="2" creationId="{B3AE647F-F189-2423-0A05-5574E8D5E7E8}"/>
            </ac:spMkLst>
          </pc:spChg>
          <pc:spChg chg="mod">
            <ac:chgData name="Song, Ziliang" userId="81d16429-0f9a-4185-9336-86602ad2fda1" providerId="ADAL" clId="{01877568-1086-49AD-8E62-3486DBC9DE55}" dt="2023-01-17T16:07:25.709" v="2"/>
            <ac:spMkLst>
              <pc:docMk/>
              <pc:sldMasterMk cId="2306245397" sldId="2147483648"/>
              <pc:sldLayoutMk cId="3968457529" sldId="2147483659"/>
              <ac:spMk id="3" creationId="{D74E9A2B-9C0C-3382-7486-E85FF3B6D4B2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5AF7B6-2BCA-40DB-86D9-9501BB7DD09F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DAFD4D-D846-4040-92D1-37EFE70EFA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26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8908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0105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4783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4303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4312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4558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DAFD4D-D846-4040-92D1-37EFE70EFA8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707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3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567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212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79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741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013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687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577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05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332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8B610-C3B2-49CB-9F68-7DFA5357999E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D539E-5884-40B8-8B2E-7483D479B3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223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1A68ACD-3A1C-A69F-2D6E-ECA9A52409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703" t="22082" r="33889" b="24603"/>
          <a:stretch/>
        </p:blipFill>
        <p:spPr>
          <a:xfrm>
            <a:off x="1408662" y="753719"/>
            <a:ext cx="6326676" cy="53505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212C1FF-725C-7428-D455-1C097F03105A}"/>
              </a:ext>
            </a:extLst>
          </p:cNvPr>
          <p:cNvSpPr txBox="1"/>
          <p:nvPr/>
        </p:nvSpPr>
        <p:spPr>
          <a:xfrm>
            <a:off x="2046950" y="902499"/>
            <a:ext cx="2525050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600" dirty="0"/>
              <a:t>(a) G14-170N and G11-516P</a:t>
            </a:r>
          </a:p>
        </p:txBody>
      </p:sp>
    </p:spTree>
    <p:extLst>
      <p:ext uri="{BB962C8B-B14F-4D97-AF65-F5344CB8AC3E}">
        <p14:creationId xmlns:p14="http://schemas.microsoft.com/office/powerpoint/2010/main" val="2340565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A9B9862-1888-9569-9A30-935EEB1DBA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352" t="15418" r="30185" b="17037"/>
          <a:stretch/>
        </p:blipFill>
        <p:spPr>
          <a:xfrm>
            <a:off x="1266942" y="592853"/>
            <a:ext cx="6610116" cy="567229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BA15E2-FC30-3853-AB08-834E07CD1318}"/>
              </a:ext>
            </a:extLst>
          </p:cNvPr>
          <p:cNvSpPr txBox="1"/>
          <p:nvPr/>
        </p:nvSpPr>
        <p:spPr>
          <a:xfrm>
            <a:off x="1795035" y="592853"/>
            <a:ext cx="2353528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b) G3-449N and G4-136N</a:t>
            </a:r>
          </a:p>
        </p:txBody>
      </p:sp>
    </p:spTree>
    <p:extLst>
      <p:ext uri="{BB962C8B-B14F-4D97-AF65-F5344CB8AC3E}">
        <p14:creationId xmlns:p14="http://schemas.microsoft.com/office/powerpoint/2010/main" val="2753348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C3FB70D-971E-B71F-72A1-B3EB0033E4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945" r="21852"/>
          <a:stretch/>
        </p:blipFill>
        <p:spPr>
          <a:xfrm>
            <a:off x="1016000" y="176534"/>
            <a:ext cx="7112000" cy="650493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C9D60A-D47C-72BE-C365-CB44E6AA8D52}"/>
              </a:ext>
            </a:extLst>
          </p:cNvPr>
          <p:cNvSpPr txBox="1"/>
          <p:nvPr/>
        </p:nvSpPr>
        <p:spPr>
          <a:xfrm>
            <a:off x="1391764" y="107954"/>
            <a:ext cx="2715808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c) Lu2-51734 and Lu13-23576</a:t>
            </a:r>
          </a:p>
        </p:txBody>
      </p:sp>
    </p:spTree>
    <p:extLst>
      <p:ext uri="{BB962C8B-B14F-4D97-AF65-F5344CB8AC3E}">
        <p14:creationId xmlns:p14="http://schemas.microsoft.com/office/powerpoint/2010/main" val="12295997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15BF896-3D68-14E0-E988-23412D369AA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389" t="9113" r="27037" b="10914"/>
          <a:stretch/>
        </p:blipFill>
        <p:spPr>
          <a:xfrm>
            <a:off x="897466" y="185474"/>
            <a:ext cx="7349067" cy="648705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B800F5D-163B-A95B-CF4C-920FA861BD94}"/>
              </a:ext>
            </a:extLst>
          </p:cNvPr>
          <p:cNvSpPr txBox="1"/>
          <p:nvPr/>
        </p:nvSpPr>
        <p:spPr>
          <a:xfrm>
            <a:off x="1433225" y="185474"/>
            <a:ext cx="2574744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d) Lu5-45630 and Lu8-3470</a:t>
            </a:r>
          </a:p>
        </p:txBody>
      </p:sp>
    </p:spTree>
    <p:extLst>
      <p:ext uri="{BB962C8B-B14F-4D97-AF65-F5344CB8AC3E}">
        <p14:creationId xmlns:p14="http://schemas.microsoft.com/office/powerpoint/2010/main" val="357226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A9C9AE0-A431-CBDA-7DE5-AA2044713AB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463" t="15777" r="30463" b="16317"/>
          <a:stretch/>
        </p:blipFill>
        <p:spPr>
          <a:xfrm>
            <a:off x="1240788" y="453012"/>
            <a:ext cx="6662423" cy="595197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34B0F0F-7F68-4D1D-5211-AFC62B85FDB0}"/>
              </a:ext>
            </a:extLst>
          </p:cNvPr>
          <p:cNvSpPr txBox="1"/>
          <p:nvPr/>
        </p:nvSpPr>
        <p:spPr>
          <a:xfrm>
            <a:off x="1756052" y="437394"/>
            <a:ext cx="2523447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e) Lu5-46938 and Lu8-2811</a:t>
            </a:r>
          </a:p>
        </p:txBody>
      </p:sp>
    </p:spTree>
    <p:extLst>
      <p:ext uri="{BB962C8B-B14F-4D97-AF65-F5344CB8AC3E}">
        <p14:creationId xmlns:p14="http://schemas.microsoft.com/office/powerpoint/2010/main" val="30777700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4FDE20C-9617-1589-218B-117147826F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222" r="22222"/>
          <a:stretch/>
        </p:blipFill>
        <p:spPr>
          <a:xfrm>
            <a:off x="880533" y="13239"/>
            <a:ext cx="7365998" cy="6815855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35832D7-7E81-CCCB-ED47-A5A3B1CDFCA8}"/>
              </a:ext>
            </a:extLst>
          </p:cNvPr>
          <p:cNvCxnSpPr>
            <a:cxnSpLocks/>
          </p:cNvCxnSpPr>
          <p:nvPr/>
        </p:nvCxnSpPr>
        <p:spPr>
          <a:xfrm>
            <a:off x="1227667" y="2613024"/>
            <a:ext cx="6400800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C8F7CE8-70A2-7997-FECC-D30686168609}"/>
              </a:ext>
            </a:extLst>
          </p:cNvPr>
          <p:cNvCxnSpPr>
            <a:cxnSpLocks/>
          </p:cNvCxnSpPr>
          <p:nvPr/>
        </p:nvCxnSpPr>
        <p:spPr>
          <a:xfrm>
            <a:off x="1227667" y="4664593"/>
            <a:ext cx="6400800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151086A-0DE5-46DE-4E12-39CC42298B81}"/>
              </a:ext>
            </a:extLst>
          </p:cNvPr>
          <p:cNvCxnSpPr>
            <a:cxnSpLocks/>
          </p:cNvCxnSpPr>
          <p:nvPr/>
        </p:nvCxnSpPr>
        <p:spPr>
          <a:xfrm>
            <a:off x="1227667" y="5782728"/>
            <a:ext cx="6400800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48DA648-8E4C-D82B-493C-9938E81215E8}"/>
              </a:ext>
            </a:extLst>
          </p:cNvPr>
          <p:cNvCxnSpPr>
            <a:cxnSpLocks/>
          </p:cNvCxnSpPr>
          <p:nvPr/>
        </p:nvCxnSpPr>
        <p:spPr>
          <a:xfrm>
            <a:off x="3606799" y="186267"/>
            <a:ext cx="0" cy="636857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6B288FA-9EF3-5B87-70BC-7CD1D486FD07}"/>
              </a:ext>
            </a:extLst>
          </p:cNvPr>
          <p:cNvCxnSpPr>
            <a:cxnSpLocks/>
          </p:cNvCxnSpPr>
          <p:nvPr/>
        </p:nvCxnSpPr>
        <p:spPr>
          <a:xfrm>
            <a:off x="5655727" y="186267"/>
            <a:ext cx="0" cy="636857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ight Triangle 14">
            <a:extLst>
              <a:ext uri="{FF2B5EF4-FFF2-40B4-BE49-F238E27FC236}">
                <a16:creationId xmlns:a16="http://schemas.microsoft.com/office/drawing/2014/main" id="{036F0DAA-EA07-578B-65C4-9B3328888164}"/>
              </a:ext>
            </a:extLst>
          </p:cNvPr>
          <p:cNvSpPr/>
          <p:nvPr/>
        </p:nvSpPr>
        <p:spPr>
          <a:xfrm rot="10800000">
            <a:off x="1368424" y="306332"/>
            <a:ext cx="2235193" cy="2232519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9967E0F-E489-B79F-E3D3-DB8E2039C30A}"/>
              </a:ext>
            </a:extLst>
          </p:cNvPr>
          <p:cNvCxnSpPr>
            <a:cxnSpLocks/>
          </p:cNvCxnSpPr>
          <p:nvPr/>
        </p:nvCxnSpPr>
        <p:spPr>
          <a:xfrm>
            <a:off x="6781789" y="186267"/>
            <a:ext cx="0" cy="636857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F78F3A46-7273-B705-0EE0-9E4973EB412F}"/>
              </a:ext>
            </a:extLst>
          </p:cNvPr>
          <p:cNvSpPr txBox="1"/>
          <p:nvPr/>
        </p:nvSpPr>
        <p:spPr>
          <a:xfrm>
            <a:off x="2432846" y="880530"/>
            <a:ext cx="869149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6-41637</a:t>
            </a:r>
          </a:p>
        </p:txBody>
      </p:sp>
      <p:sp>
        <p:nvSpPr>
          <p:cNvPr id="18" name="Right Triangle 17">
            <a:extLst>
              <a:ext uri="{FF2B5EF4-FFF2-40B4-BE49-F238E27FC236}">
                <a16:creationId xmlns:a16="http://schemas.microsoft.com/office/drawing/2014/main" id="{3DF47C10-A10B-8FF2-E952-C64A912CB3A2}"/>
              </a:ext>
            </a:extLst>
          </p:cNvPr>
          <p:cNvSpPr/>
          <p:nvPr/>
        </p:nvSpPr>
        <p:spPr>
          <a:xfrm rot="10800000">
            <a:off x="3670296" y="2613014"/>
            <a:ext cx="1985421" cy="1982265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9E9B2B-1705-7531-940B-B6A5332BA1D8}"/>
              </a:ext>
            </a:extLst>
          </p:cNvPr>
          <p:cNvSpPr txBox="1"/>
          <p:nvPr/>
        </p:nvSpPr>
        <p:spPr>
          <a:xfrm>
            <a:off x="4529666" y="3093553"/>
            <a:ext cx="940386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2-11698</a:t>
            </a:r>
          </a:p>
        </p:txBody>
      </p:sp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0A802746-33E3-C915-398C-C35D497F00F2}"/>
              </a:ext>
            </a:extLst>
          </p:cNvPr>
          <p:cNvSpPr/>
          <p:nvPr/>
        </p:nvSpPr>
        <p:spPr>
          <a:xfrm rot="10800000">
            <a:off x="5718183" y="4664593"/>
            <a:ext cx="1063604" cy="1053581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735AFA-D780-2363-12C7-62272B9F806F}"/>
              </a:ext>
            </a:extLst>
          </p:cNvPr>
          <p:cNvSpPr txBox="1"/>
          <p:nvPr/>
        </p:nvSpPr>
        <p:spPr>
          <a:xfrm rot="2668054">
            <a:off x="5902807" y="4924932"/>
            <a:ext cx="940386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2-11761</a:t>
            </a:r>
          </a:p>
        </p:txBody>
      </p:sp>
      <p:sp>
        <p:nvSpPr>
          <p:cNvPr id="22" name="Right Triangle 21">
            <a:extLst>
              <a:ext uri="{FF2B5EF4-FFF2-40B4-BE49-F238E27FC236}">
                <a16:creationId xmlns:a16="http://schemas.microsoft.com/office/drawing/2014/main" id="{5D0B1245-0232-5057-270B-829F3895312F}"/>
              </a:ext>
            </a:extLst>
          </p:cNvPr>
          <p:cNvSpPr/>
          <p:nvPr/>
        </p:nvSpPr>
        <p:spPr>
          <a:xfrm rot="10800000">
            <a:off x="6844241" y="5782728"/>
            <a:ext cx="173562" cy="181510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234ACA6-66CA-7574-7503-7D293F92179C}"/>
              </a:ext>
            </a:extLst>
          </p:cNvPr>
          <p:cNvSpPr txBox="1"/>
          <p:nvPr/>
        </p:nvSpPr>
        <p:spPr>
          <a:xfrm>
            <a:off x="7057829" y="6089983"/>
            <a:ext cx="869149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4-576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D0F2212-3CF0-00F3-3830-FD677E944BBF}"/>
              </a:ext>
            </a:extLst>
          </p:cNvPr>
          <p:cNvSpPr txBox="1"/>
          <p:nvPr/>
        </p:nvSpPr>
        <p:spPr>
          <a:xfrm>
            <a:off x="1268130" y="-118736"/>
            <a:ext cx="4804329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f) Lu6-41637, Lu12-11761, Lu12-11698 and Lu14-5765 </a:t>
            </a:r>
          </a:p>
        </p:txBody>
      </p:sp>
    </p:spTree>
    <p:extLst>
      <p:ext uri="{BB962C8B-B14F-4D97-AF65-F5344CB8AC3E}">
        <p14:creationId xmlns:p14="http://schemas.microsoft.com/office/powerpoint/2010/main" val="1131641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2E6150E-D7FD-8AE1-BB1C-9385AA541A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204" r="21759"/>
          <a:stretch/>
        </p:blipFill>
        <p:spPr>
          <a:xfrm>
            <a:off x="807882" y="109595"/>
            <a:ext cx="7487591" cy="6748405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41BF29EE-1593-ED35-8FF9-15CBDE29EBF3}"/>
              </a:ext>
            </a:extLst>
          </p:cNvPr>
          <p:cNvCxnSpPr>
            <a:cxnSpLocks/>
          </p:cNvCxnSpPr>
          <p:nvPr/>
        </p:nvCxnSpPr>
        <p:spPr>
          <a:xfrm>
            <a:off x="4893733" y="152399"/>
            <a:ext cx="0" cy="6620934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1CB61F7-7956-36D2-B84A-0923A0EB4893}"/>
              </a:ext>
            </a:extLst>
          </p:cNvPr>
          <p:cNvCxnSpPr>
            <a:cxnSpLocks/>
          </p:cNvCxnSpPr>
          <p:nvPr/>
        </p:nvCxnSpPr>
        <p:spPr>
          <a:xfrm>
            <a:off x="1092199" y="3001435"/>
            <a:ext cx="6620933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ight Triangle 9">
            <a:extLst>
              <a:ext uri="{FF2B5EF4-FFF2-40B4-BE49-F238E27FC236}">
                <a16:creationId xmlns:a16="http://schemas.microsoft.com/office/drawing/2014/main" id="{C45BF706-2430-0C06-CE73-5EEDBC81E11F}"/>
              </a:ext>
            </a:extLst>
          </p:cNvPr>
          <p:cNvSpPr/>
          <p:nvPr/>
        </p:nvSpPr>
        <p:spPr>
          <a:xfrm rot="10800000">
            <a:off x="1260475" y="234948"/>
            <a:ext cx="2688380" cy="2673349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AC0711-0AD6-4319-3831-7B82140573BF}"/>
              </a:ext>
            </a:extLst>
          </p:cNvPr>
          <p:cNvSpPr txBox="1"/>
          <p:nvPr/>
        </p:nvSpPr>
        <p:spPr>
          <a:xfrm>
            <a:off x="2607729" y="903477"/>
            <a:ext cx="98057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0-34966</a:t>
            </a:r>
          </a:p>
        </p:txBody>
      </p:sp>
      <p:sp>
        <p:nvSpPr>
          <p:cNvPr id="12" name="Right Triangle 11">
            <a:extLst>
              <a:ext uri="{FF2B5EF4-FFF2-40B4-BE49-F238E27FC236}">
                <a16:creationId xmlns:a16="http://schemas.microsoft.com/office/drawing/2014/main" id="{2A560857-23AD-DCAC-BEA8-B061CDD2DD96}"/>
              </a:ext>
            </a:extLst>
          </p:cNvPr>
          <p:cNvSpPr/>
          <p:nvPr/>
        </p:nvSpPr>
        <p:spPr>
          <a:xfrm rot="10800000">
            <a:off x="4038598" y="3001431"/>
            <a:ext cx="855131" cy="872075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BD07EF-99B6-05B8-52A6-AD00C1EFA991}"/>
              </a:ext>
            </a:extLst>
          </p:cNvPr>
          <p:cNvSpPr txBox="1"/>
          <p:nvPr/>
        </p:nvSpPr>
        <p:spPr>
          <a:xfrm rot="2668054">
            <a:off x="4081485" y="3161741"/>
            <a:ext cx="940386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1-24918</a:t>
            </a:r>
          </a:p>
        </p:txBody>
      </p:sp>
      <p:sp>
        <p:nvSpPr>
          <p:cNvPr id="14" name="Right Triangle 13">
            <a:extLst>
              <a:ext uri="{FF2B5EF4-FFF2-40B4-BE49-F238E27FC236}">
                <a16:creationId xmlns:a16="http://schemas.microsoft.com/office/drawing/2014/main" id="{5CD02E59-C032-4EE4-34F1-9434D84EFF56}"/>
              </a:ext>
            </a:extLst>
          </p:cNvPr>
          <p:cNvSpPr/>
          <p:nvPr/>
        </p:nvSpPr>
        <p:spPr>
          <a:xfrm rot="10800000">
            <a:off x="4992690" y="3958168"/>
            <a:ext cx="1919272" cy="1920343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t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6125A9-29DD-27B4-0AA4-E841F2715242}"/>
              </a:ext>
            </a:extLst>
          </p:cNvPr>
          <p:cNvSpPr txBox="1"/>
          <p:nvPr/>
        </p:nvSpPr>
        <p:spPr>
          <a:xfrm>
            <a:off x="5770815" y="4374810"/>
            <a:ext cx="980574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11-28070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97F6C2B-EACA-F062-57A7-07CBFBA549ED}"/>
              </a:ext>
            </a:extLst>
          </p:cNvPr>
          <p:cNvCxnSpPr>
            <a:cxnSpLocks/>
          </p:cNvCxnSpPr>
          <p:nvPr/>
        </p:nvCxnSpPr>
        <p:spPr>
          <a:xfrm>
            <a:off x="1109127" y="3958177"/>
            <a:ext cx="6620933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6EFE5A9-33D0-1973-DC70-9623CDC2FDCD}"/>
              </a:ext>
            </a:extLst>
          </p:cNvPr>
          <p:cNvCxnSpPr>
            <a:cxnSpLocks/>
          </p:cNvCxnSpPr>
          <p:nvPr/>
        </p:nvCxnSpPr>
        <p:spPr>
          <a:xfrm>
            <a:off x="3948855" y="150799"/>
            <a:ext cx="0" cy="6620934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855795BF-F9CC-3E8B-2654-7B45AF43CDFF}"/>
              </a:ext>
            </a:extLst>
          </p:cNvPr>
          <p:cNvSpPr txBox="1"/>
          <p:nvPr/>
        </p:nvSpPr>
        <p:spPr>
          <a:xfrm>
            <a:off x="1148529" y="-222541"/>
            <a:ext cx="3960764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g) Lu10-34966, Lu11-24918 and Lu11-28070 </a:t>
            </a:r>
          </a:p>
        </p:txBody>
      </p:sp>
    </p:spTree>
    <p:extLst>
      <p:ext uri="{BB962C8B-B14F-4D97-AF65-F5344CB8AC3E}">
        <p14:creationId xmlns:p14="http://schemas.microsoft.com/office/powerpoint/2010/main" val="26755299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54D5C9F-632F-DAC0-5A80-3549DCD3C8C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407" t="10734" r="27778" b="12175"/>
          <a:stretch/>
        </p:blipFill>
        <p:spPr>
          <a:xfrm>
            <a:off x="952856" y="228600"/>
            <a:ext cx="7238287" cy="64008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93B6982-3461-7AEB-A530-9272B9C3E940}"/>
              </a:ext>
            </a:extLst>
          </p:cNvPr>
          <p:cNvSpPr txBox="1"/>
          <p:nvPr/>
        </p:nvSpPr>
        <p:spPr>
          <a:xfrm>
            <a:off x="1377221" y="228600"/>
            <a:ext cx="3866764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600" dirty="0"/>
              <a:t>(h) Lu9-15288, Lu10-38024 and Lu10-38063 </a:t>
            </a:r>
          </a:p>
        </p:txBody>
      </p:sp>
    </p:spTree>
    <p:extLst>
      <p:ext uri="{BB962C8B-B14F-4D97-AF65-F5344CB8AC3E}">
        <p14:creationId xmlns:p14="http://schemas.microsoft.com/office/powerpoint/2010/main" val="1498467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5</TotalTime>
  <Words>70</Words>
  <Application>Microsoft Office PowerPoint</Application>
  <PresentationFormat>On-screen Show (4:3)</PresentationFormat>
  <Paragraphs>22</Paragraphs>
  <Slides>8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askatchewa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Ziliang</dc:creator>
  <cp:lastModifiedBy>Song, Ziliang</cp:lastModifiedBy>
  <cp:revision>1</cp:revision>
  <dcterms:created xsi:type="dcterms:W3CDTF">2023-01-17T16:07:11Z</dcterms:created>
  <dcterms:modified xsi:type="dcterms:W3CDTF">2023-04-28T14:18:22Z</dcterms:modified>
</cp:coreProperties>
</file>